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1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  <p:sldId id="263" r:id="rId3"/>
    <p:sldId id="260" r:id="rId4"/>
    <p:sldId id="262" r:id="rId5"/>
    <p:sldId id="261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9" orient="horz" pos="5659" userDrawn="1">
          <p15:clr>
            <a:srgbClr val="A4A3A4"/>
          </p15:clr>
        </p15:guide>
        <p15:guide id="13" orient="horz" pos="2531" userDrawn="1">
          <p15:clr>
            <a:srgbClr val="A4A3A4"/>
          </p15:clr>
        </p15:guide>
        <p15:guide id="15" orient="horz" pos="2575" userDrawn="1">
          <p15:clr>
            <a:srgbClr val="A4A3A4"/>
          </p15:clr>
        </p15:guide>
        <p15:guide id="22" pos="3974" userDrawn="1">
          <p15:clr>
            <a:srgbClr val="A4A3A4"/>
          </p15:clr>
        </p15:guide>
        <p15:guide id="24" orient="horz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7D7D7"/>
    <a:srgbClr val="9DC3E6"/>
    <a:srgbClr val="2F5597"/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16" autoAdjust="0"/>
    <p:restoredTop sz="94660"/>
  </p:normalViewPr>
  <p:slideViewPr>
    <p:cSldViewPr showGuides="1">
      <p:cViewPr varScale="1">
        <p:scale>
          <a:sx n="90" d="100"/>
          <a:sy n="90" d="100"/>
        </p:scale>
        <p:origin x="3186" y="90"/>
      </p:cViewPr>
      <p:guideLst>
        <p:guide orient="horz" pos="5659"/>
        <p:guide orient="horz" pos="2531"/>
        <p:guide orient="horz" pos="2575"/>
        <p:guide pos="3974"/>
        <p:guide orient="horz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pdr-1\2016-05-27_Bradford_WT-dPDR1-Ppdr1_0,2%25&amp;1%25pe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Review_2016-11-29\qPCR\2017-02-14_WT-gh28-1oex-comp_pec_check_results_mod.XLS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ENCODE\2016-08-03_WT-on-Rha-suc-noc-pec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pdr-1\2016-08-03_Biomasse-1%25xylan-plus-Rha-or-GalA_wt-d9033-d9033Pgpd1pdr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pdr-1\2016-06-17_Biomasse-1%25xylan&amp;2%25sucrose_wt-d9033-d9033Pgpd1pdr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Review_2016-11-29\ENCODE\2017-02-24_qPCR&amp;RNAseq_correl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Review_2016-11-29\ENCODE\2017-02-24_qPCR&amp;RNAseq_correl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unke_000\Desktop\Review_2016-11-29\qPCR\2017-02-14_WT-pdr1oex_xln-rha_pdr1_check_results_m.XL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Review_2016-11-29\qPCR\2017-02-14_WT-pdr1oex_xln-rha_9034_check_results_m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Review_2016-11-29\qPCR\2017-02-14_WT-pdr1oex_xln-rha_9034_check_results_m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Review_2016-11-29\qPCR\2017-02-14_WT-pdr1oex_xln-rha_pdr1_check_results_m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tuwzx7s-file01.forst.wzw.tum.de\data\s9a\bioprozesse\projekte\2014%20PhD-Student%20Nils%20Thieme\Images%20&amp;%20tables%20for%20pdr-1%20paper\Review_2016-11-29\qPCR\2017-02-14_WT-pdr1oex_xln-rha_pdr1_check_results_m.XLS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tuwzx7s-file01.forst.wzw.tum.de\data\s9a\bioprozesse\projekte\2014%20PhD-Student%20Nils%20Thieme\Images%20&amp;%20tables%20for%20pdr-1%20paper\Review_2016-11-29\qPCR\2017-01-12_qPCR_pdr1oex-gh28-1oex-check-pec_result_analyze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61</c:f>
              <c:strCache>
                <c:ptCount val="1"/>
                <c:pt idx="0">
                  <c:v>0.2% pectin, vivaspin concentrated</c:v>
                </c:pt>
              </c:strCache>
            </c:strRef>
          </c:tx>
          <c:spPr>
            <a:solidFill>
              <a:schemeClr val="accent2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ED4-48A5-9840-C51B35AF1A52}"/>
              </c:ext>
            </c:extLst>
          </c:dPt>
          <c:dPt>
            <c:idx val="1"/>
            <c:invertIfNegative val="0"/>
            <c:bubble3D val="0"/>
            <c:spPr>
              <a:solidFill>
                <a:srgbClr val="9DC3E6"/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ED4-48A5-9840-C51B35AF1A5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ED4-48A5-9840-C51B35AF1A52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B$64:$G$64</c:f>
                <c:numCache>
                  <c:formatCode>General</c:formatCode>
                  <c:ptCount val="6"/>
                  <c:pt idx="0">
                    <c:v>0.93731679655816968</c:v>
                  </c:pt>
                  <c:pt idx="1">
                    <c:v>1.3438736303681602</c:v>
                  </c:pt>
                  <c:pt idx="2">
                    <c:v>1.388812384138534</c:v>
                  </c:pt>
                  <c:pt idx="3">
                    <c:v>1.3507499439073152</c:v>
                  </c:pt>
                  <c:pt idx="4">
                    <c:v>1.8835881265046843</c:v>
                  </c:pt>
                  <c:pt idx="5">
                    <c:v>0.69630304566174595</c:v>
                  </c:pt>
                </c:numCache>
              </c:numRef>
            </c:plus>
            <c:minus>
              <c:numRef>
                <c:f>Sheet2!$B$64:$G$64</c:f>
                <c:numCache>
                  <c:formatCode>General</c:formatCode>
                  <c:ptCount val="6"/>
                  <c:pt idx="0">
                    <c:v>0.93731679655816968</c:v>
                  </c:pt>
                  <c:pt idx="1">
                    <c:v>1.3438736303681602</c:v>
                  </c:pt>
                  <c:pt idx="2">
                    <c:v>1.388812384138534</c:v>
                  </c:pt>
                  <c:pt idx="3">
                    <c:v>1.3507499439073152</c:v>
                  </c:pt>
                  <c:pt idx="4">
                    <c:v>1.8835881265046843</c:v>
                  </c:pt>
                  <c:pt idx="5">
                    <c:v>0.696303045661745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62:$D$62</c:f>
              <c:strCache>
                <c:ptCount val="3"/>
                <c:pt idx="0">
                  <c:v>WT</c:v>
                </c:pt>
                <c:pt idx="1">
                  <c:v>Δpdr-1</c:v>
                </c:pt>
                <c:pt idx="2">
                  <c:v>pdr-1-comp</c:v>
                </c:pt>
              </c:strCache>
            </c:strRef>
          </c:cat>
          <c:val>
            <c:numRef>
              <c:f>Sheet2!$B$63:$D$63</c:f>
              <c:numCache>
                <c:formatCode>General</c:formatCode>
                <c:ptCount val="3"/>
                <c:pt idx="0">
                  <c:v>5.6652171743088902</c:v>
                </c:pt>
                <c:pt idx="1">
                  <c:v>2.928984015920888</c:v>
                </c:pt>
                <c:pt idx="2">
                  <c:v>7.82463829344597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7ED4-48A5-9840-C51B35AF1A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17"/>
        <c:axId val="439176888"/>
        <c:axId val="439177280"/>
      </c:barChart>
      <c:catAx>
        <c:axId val="43917688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177280"/>
        <c:crosses val="autoZero"/>
        <c:auto val="1"/>
        <c:lblAlgn val="ctr"/>
        <c:lblOffset val="100"/>
        <c:noMultiLvlLbl val="0"/>
      </c:catAx>
      <c:valAx>
        <c:axId val="4391772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9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 concentration [mg/ml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9176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15256734639057"/>
          <c:y val="4.8301451353889975E-2"/>
          <c:w val="0.77075021115040676"/>
          <c:h val="0.749891426205169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h28-1'!$Q$30</c:f>
              <c:strCache>
                <c:ptCount val="1"/>
                <c:pt idx="0">
                  <c:v>gh28-1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/>
          </c:dPt>
          <c:dPt>
            <c:idx val="1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/>
          </c:dPt>
          <c:dPt>
            <c:idx val="2"/>
            <c:invertIfNegative val="0"/>
            <c:bubble3D val="0"/>
            <c:spPr>
              <a:solidFill>
                <a:schemeClr val="accent1">
                  <a:lumMod val="50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/>
          </c:dPt>
          <c:errBars>
            <c:errBarType val="both"/>
            <c:errValType val="cust"/>
            <c:noEndCap val="0"/>
            <c:plus>
              <c:numRef>
                <c:f>('gh28-1'!$V$4,'gh28-1'!$V$8,'gh28-1'!$V$12)</c:f>
                <c:numCache>
                  <c:formatCode>General</c:formatCode>
                  <c:ptCount val="3"/>
                  <c:pt idx="0">
                    <c:v>0.80228767765944331</c:v>
                  </c:pt>
                  <c:pt idx="1">
                    <c:v>1.727592465934533</c:v>
                  </c:pt>
                  <c:pt idx="2">
                    <c:v>1.763017366550601</c:v>
                  </c:pt>
                </c:numCache>
              </c:numRef>
            </c:plus>
            <c:minus>
              <c:numRef>
                <c:f>('gh28-1'!$V$4,'gh28-1'!$V$8,'gh28-1'!$V$12)</c:f>
                <c:numCache>
                  <c:formatCode>General</c:formatCode>
                  <c:ptCount val="3"/>
                  <c:pt idx="0">
                    <c:v>0.80228767765944331</c:v>
                  </c:pt>
                  <c:pt idx="1">
                    <c:v>1.727592465934533</c:v>
                  </c:pt>
                  <c:pt idx="2">
                    <c:v>1.76301736655060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gh28-1'!$Q$32:$Q$34</c:f>
              <c:strCache>
                <c:ptCount val="3"/>
                <c:pt idx="0">
                  <c:v>WT</c:v>
                </c:pt>
                <c:pt idx="1">
                  <c:v>gh28-1-comp</c:v>
                </c:pt>
                <c:pt idx="2">
                  <c:v>gh28-1-oex</c:v>
                </c:pt>
              </c:strCache>
            </c:strRef>
          </c:cat>
          <c:val>
            <c:numRef>
              <c:f>('gh28-1'!$U$4,'gh28-1'!$U$8,'gh28-1'!$U$12)</c:f>
              <c:numCache>
                <c:formatCode>General</c:formatCode>
                <c:ptCount val="3"/>
                <c:pt idx="0">
                  <c:v>1.2190655858092976</c:v>
                </c:pt>
                <c:pt idx="1">
                  <c:v>3.8459056609346831</c:v>
                </c:pt>
                <c:pt idx="2">
                  <c:v>3.8958476830931983</c:v>
                </c:pt>
              </c:numCache>
            </c:numRef>
          </c:val>
          <c:extLst xmlns:c16r2="http://schemas.microsoft.com/office/drawing/2015/06/chart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41704080"/>
        <c:axId val="441704472"/>
      </c:barChart>
      <c:catAx>
        <c:axId val="441704080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4472"/>
        <c:crosses val="autoZero"/>
        <c:auto val="1"/>
        <c:lblAlgn val="ctr"/>
        <c:lblOffset val="100"/>
        <c:noMultiLvlLbl val="0"/>
      </c:catAx>
      <c:valAx>
        <c:axId val="4417044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WT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0459962154027388E-2"/>
              <c:y val="8.182361050792337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4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76017183645652"/>
          <c:y val="2.7777777777777776E-2"/>
          <c:w val="0.78351314219894674"/>
          <c:h val="0.81330963837853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vg!$A$3</c:f>
              <c:strCache>
                <c:ptCount val="1"/>
                <c:pt idx="0">
                  <c:v>pdr-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E99F9F"/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C3A-4F7A-BE79-93CF5FDA427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C3A-4F7A-BE79-93CF5FDA427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C3A-4F7A-BE79-93CF5FDA4277}"/>
              </c:ext>
            </c:extLst>
          </c:dPt>
          <c:dPt>
            <c:idx val="3"/>
            <c:invertIfNegative val="0"/>
            <c:bubble3D val="0"/>
            <c:spPr>
              <a:solidFill>
                <a:srgbClr val="FFC000"/>
              </a:solidFill>
              <a:ln w="63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C3A-4F7A-BE79-93CF5FDA4277}"/>
              </c:ext>
            </c:extLst>
          </c:dPt>
          <c:errBars>
            <c:errBarType val="both"/>
            <c:errValType val="cust"/>
            <c:noEndCap val="0"/>
            <c:plus>
              <c:numRef>
                <c:f>avg!$B$5:$E$5</c:f>
                <c:numCache>
                  <c:formatCode>General</c:formatCode>
                  <c:ptCount val="4"/>
                  <c:pt idx="0">
                    <c:v>0.94217319179295889</c:v>
                  </c:pt>
                  <c:pt idx="1">
                    <c:v>0.14014063269920474</c:v>
                  </c:pt>
                  <c:pt idx="2">
                    <c:v>3.385453637746842</c:v>
                  </c:pt>
                  <c:pt idx="3">
                    <c:v>1.5912731003822058</c:v>
                  </c:pt>
                </c:numCache>
              </c:numRef>
            </c:plus>
            <c:minus>
              <c:numRef>
                <c:f>avg!$B$5:$E$5</c:f>
                <c:numCache>
                  <c:formatCode>General</c:formatCode>
                  <c:ptCount val="4"/>
                  <c:pt idx="0">
                    <c:v>0.94217319179295889</c:v>
                  </c:pt>
                  <c:pt idx="1">
                    <c:v>0.14014063269920474</c:v>
                  </c:pt>
                  <c:pt idx="2">
                    <c:v>3.385453637746842</c:v>
                  </c:pt>
                  <c:pt idx="3">
                    <c:v>1.59127310038220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g!$B$3:$E$3</c:f>
              <c:strCache>
                <c:ptCount val="4"/>
                <c:pt idx="0">
                  <c:v>NoC</c:v>
                </c:pt>
                <c:pt idx="1">
                  <c:v>sucrose</c:v>
                </c:pt>
                <c:pt idx="2">
                  <c:v>L-Rha</c:v>
                </c:pt>
                <c:pt idx="3">
                  <c:v>pectin</c:v>
                </c:pt>
              </c:strCache>
            </c:strRef>
          </c:cat>
          <c:val>
            <c:numRef>
              <c:f>avg!$B$4:$E$4</c:f>
              <c:numCache>
                <c:formatCode>General</c:formatCode>
                <c:ptCount val="4"/>
                <c:pt idx="0">
                  <c:v>17.110933333333335</c:v>
                </c:pt>
                <c:pt idx="1">
                  <c:v>7.9201333333333332</c:v>
                </c:pt>
                <c:pt idx="2">
                  <c:v>149.15833333333333</c:v>
                </c:pt>
                <c:pt idx="3">
                  <c:v>39.1636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CC3A-4F7A-BE79-93CF5FDA4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41705256"/>
        <c:axId val="441705648"/>
      </c:barChart>
      <c:catAx>
        <c:axId val="44170525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5648"/>
        <c:crosses val="autoZero"/>
        <c:auto val="1"/>
        <c:lblAlgn val="ctr"/>
        <c:lblOffset val="100"/>
        <c:noMultiLvlLbl val="0"/>
      </c:catAx>
      <c:valAx>
        <c:axId val="441705648"/>
        <c:scaling>
          <c:orientation val="minMax"/>
          <c:max val="1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r-1 expression [FPKM]</a:t>
                </a:r>
              </a:p>
            </c:rich>
          </c:tx>
          <c:layout>
            <c:manualLayout>
              <c:xMode val="edge"/>
              <c:yMode val="edge"/>
              <c:x val="2.5782081859124947E-2"/>
              <c:y val="0.144438595494738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5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702727034103658"/>
          <c:y val="5.364467140792404E-2"/>
          <c:w val="0.68905568616364077"/>
          <c:h val="0.742565981031394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47:$O$48</c:f>
                <c:numCache>
                  <c:formatCode>General</c:formatCode>
                  <c:ptCount val="2"/>
                  <c:pt idx="0">
                    <c:v>4.1162578391285862</c:v>
                  </c:pt>
                  <c:pt idx="1">
                    <c:v>9.5185134095493726</c:v>
                  </c:pt>
                </c:numCache>
                <c:extLst xmlns:c16r2="http://schemas.microsoft.com/office/drawing/2015/06/chart"/>
              </c:numRef>
            </c:plus>
            <c:minus>
              <c:numRef>
                <c:f>Sheet1!$O$47:$O$48</c:f>
                <c:numCache>
                  <c:formatCode>General</c:formatCode>
                  <c:ptCount val="2"/>
                  <c:pt idx="0">
                    <c:v>4.1162578391285862</c:v>
                  </c:pt>
                  <c:pt idx="1">
                    <c:v>9.5185134095493726</c:v>
                  </c:pt>
                </c:numCache>
                <c:extLst xmlns:c16r2="http://schemas.microsoft.com/office/drawing/2015/06/chart"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43:$M$44</c:f>
              <c:strCache>
                <c:ptCount val="2"/>
                <c:pt idx="0">
                  <c:v>1% xylan + 0.5 mM L-Rha</c:v>
                </c:pt>
                <c:pt idx="1">
                  <c:v>1% xylan + 0.5 mM D-GalA</c:v>
                </c:pt>
              </c:strCache>
              <c:extLst xmlns:c16r2="http://schemas.microsoft.com/office/drawing/2015/06/chart"/>
            </c:strRef>
          </c:cat>
          <c:val>
            <c:numRef>
              <c:f>Sheet1!$O$43:$O$44</c:f>
              <c:numCache>
                <c:formatCode>#,#00</c:formatCode>
                <c:ptCount val="2"/>
                <c:pt idx="0">
                  <c:v>100</c:v>
                </c:pt>
                <c:pt idx="1">
                  <c:v>100</c:v>
                </c:pt>
              </c:numCache>
              <c:extLst xmlns:c16r2="http://schemas.microsoft.com/office/drawing/2015/06/chart"/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8C1-4FB6-BC81-08A3F2EA22C6}"/>
            </c:ext>
          </c:extLst>
        </c:ser>
        <c:ser>
          <c:idx val="1"/>
          <c:order val="1"/>
          <c:tx>
            <c:strRef>
              <c:f>Sheet1!$P$35</c:f>
              <c:strCache>
                <c:ptCount val="1"/>
                <c:pt idx="0">
                  <c:v>Δpdr-1</c:v>
                </c:pt>
              </c:strCache>
            </c:strRef>
          </c:tx>
          <c:spPr>
            <a:solidFill>
              <a:srgbClr val="9DC3E6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47:$P$48</c:f>
                <c:numCache>
                  <c:formatCode>General</c:formatCode>
                  <c:ptCount val="2"/>
                  <c:pt idx="0">
                    <c:v>3.4964430028401536</c:v>
                  </c:pt>
                  <c:pt idx="1">
                    <c:v>5.1349574178503925</c:v>
                  </c:pt>
                </c:numCache>
                <c:extLst xmlns:c16r2="http://schemas.microsoft.com/office/drawing/2015/06/chart"/>
              </c:numRef>
            </c:plus>
            <c:minus>
              <c:numRef>
                <c:f>Sheet1!$P$47:$P$48</c:f>
                <c:numCache>
                  <c:formatCode>General</c:formatCode>
                  <c:ptCount val="2"/>
                  <c:pt idx="0">
                    <c:v>3.4964430028401536</c:v>
                  </c:pt>
                  <c:pt idx="1">
                    <c:v>5.1349574178503925</c:v>
                  </c:pt>
                </c:numCache>
                <c:extLst xmlns:c16r2="http://schemas.microsoft.com/office/drawing/2015/06/chart"/>
              </c:numRef>
            </c:minus>
          </c:errBars>
          <c:cat>
            <c:strRef>
              <c:f>Sheet1!$M$43:$M$44</c:f>
              <c:strCache>
                <c:ptCount val="2"/>
                <c:pt idx="0">
                  <c:v>1% xylan + 0.5 mM L-Rha</c:v>
                </c:pt>
                <c:pt idx="1">
                  <c:v>1% xylan + 0.5 mM D-GalA</c:v>
                </c:pt>
              </c:strCache>
              <c:extLst xmlns:c16r2="http://schemas.microsoft.com/office/drawing/2015/06/chart"/>
            </c:strRef>
          </c:cat>
          <c:val>
            <c:numRef>
              <c:f>Sheet1!$P$43:$P$44</c:f>
              <c:numCache>
                <c:formatCode>#,#00</c:formatCode>
                <c:ptCount val="2"/>
                <c:pt idx="0">
                  <c:v>107.48663101604278</c:v>
                </c:pt>
                <c:pt idx="1">
                  <c:v>95.115681233933159</c:v>
                </c:pt>
              </c:numCache>
              <c:extLst xmlns:c16r2="http://schemas.microsoft.com/office/drawing/2015/06/chart"/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8C1-4FB6-BC81-08A3F2EA22C6}"/>
            </c:ext>
          </c:extLst>
        </c:ser>
        <c:ser>
          <c:idx val="2"/>
          <c:order val="2"/>
          <c:tx>
            <c:strRef>
              <c:f>Sheet1!$Q$35</c:f>
              <c:strCache>
                <c:ptCount val="1"/>
                <c:pt idx="0">
                  <c:v>pdr-1-oex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Q$47:$Q$48</c:f>
                <c:numCache>
                  <c:formatCode>General</c:formatCode>
                  <c:ptCount val="2"/>
                  <c:pt idx="0">
                    <c:v>5.2599774259106855</c:v>
                  </c:pt>
                  <c:pt idx="1">
                    <c:v>8.4949674251199685</c:v>
                  </c:pt>
                </c:numCache>
                <c:extLst xmlns:c16r2="http://schemas.microsoft.com/office/drawing/2015/06/chart"/>
              </c:numRef>
            </c:plus>
            <c:minus>
              <c:numRef>
                <c:f>Sheet1!$Q$47:$Q$48</c:f>
                <c:numCache>
                  <c:formatCode>General</c:formatCode>
                  <c:ptCount val="2"/>
                  <c:pt idx="0">
                    <c:v>5.2599774259106855</c:v>
                  </c:pt>
                  <c:pt idx="1">
                    <c:v>8.4949674251199685</c:v>
                  </c:pt>
                </c:numCache>
                <c:extLst xmlns:c16r2="http://schemas.microsoft.com/office/drawing/2015/06/chart"/>
              </c:numRef>
            </c:minus>
          </c:errBars>
          <c:cat>
            <c:strRef>
              <c:f>Sheet1!$M$43:$M$44</c:f>
              <c:strCache>
                <c:ptCount val="2"/>
                <c:pt idx="0">
                  <c:v>1% xylan + 0.5 mM L-Rha</c:v>
                </c:pt>
                <c:pt idx="1">
                  <c:v>1% xylan + 0.5 mM D-GalA</c:v>
                </c:pt>
              </c:strCache>
              <c:extLst xmlns:c16r2="http://schemas.microsoft.com/office/drawing/2015/06/chart"/>
            </c:strRef>
          </c:cat>
          <c:val>
            <c:numRef>
              <c:f>Sheet1!$Q$43:$Q$44</c:f>
              <c:numCache>
                <c:formatCode>#,#00</c:formatCode>
                <c:ptCount val="2"/>
                <c:pt idx="0">
                  <c:v>101.87165775401066</c:v>
                </c:pt>
                <c:pt idx="1">
                  <c:v>101.28534704370179</c:v>
                </c:pt>
              </c:numCache>
              <c:extLst xmlns:c16r2="http://schemas.microsoft.com/office/drawing/2015/06/chart"/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8C1-4FB6-BC81-08A3F2EA22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41706432"/>
        <c:axId val="441706824"/>
      </c:barChart>
      <c:catAx>
        <c:axId val="441706432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12700" cap="flat" cmpd="sng" algn="ctr">
            <a:solidFill>
              <a:schemeClr val="bg1">
                <a:lumMod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6824"/>
        <c:crosses val="autoZero"/>
        <c:auto val="1"/>
        <c:lblAlgn val="ctr"/>
        <c:lblOffset val="100"/>
        <c:noMultiLvlLbl val="0"/>
      </c:catAx>
      <c:valAx>
        <c:axId val="441706824"/>
        <c:scaling>
          <c:orientation val="minMax"/>
          <c:min val="0"/>
        </c:scaling>
        <c:delete val="1"/>
        <c:axPos val="l"/>
        <c:numFmt formatCode="General" sourceLinked="0"/>
        <c:majorTickMark val="cross"/>
        <c:minorTickMark val="none"/>
        <c:tickLblPos val="nextTo"/>
        <c:crossAx val="441706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358853741317876"/>
          <c:y val="0.93023238542568765"/>
          <c:w val="0.5249600793692496"/>
          <c:h val="6.45276683600907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2965852107300675"/>
          <c:y val="0.11651462878101856"/>
          <c:w val="0.62656077442945535"/>
          <c:h val="0.74432870548012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47:$O$49</c:f>
                <c:numCache>
                  <c:formatCode>General</c:formatCode>
                  <c:ptCount val="2"/>
                  <c:pt idx="0">
                    <c:v>2.979794442532298</c:v>
                  </c:pt>
                </c:numCache>
              </c:numRef>
            </c:plus>
            <c:minus>
              <c:numRef>
                <c:f>Sheet1!$O$47:$O$49</c:f>
                <c:numCache>
                  <c:formatCode>General</c:formatCode>
                  <c:ptCount val="2"/>
                  <c:pt idx="0">
                    <c:v>2.979794442532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0:$A$11</c:f>
              <c:strCache>
                <c:ptCount val="1"/>
                <c:pt idx="0">
                  <c:v>1% xylan</c:v>
                </c:pt>
              </c:strCache>
            </c:strRef>
          </c:cat>
          <c:val>
            <c:numRef>
              <c:f>Sheet1!$O$43:$O$44</c:f>
              <c:numCache>
                <c:formatCode>#,#00</c:formatCode>
                <c:ptCount val="1"/>
                <c:pt idx="0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73B-4195-A1A1-BDE92F6B96EB}"/>
            </c:ext>
          </c:extLst>
        </c:ser>
        <c:ser>
          <c:idx val="1"/>
          <c:order val="1"/>
          <c:tx>
            <c:strRef>
              <c:f>Sheet1!$P$35</c:f>
              <c:strCache>
                <c:ptCount val="1"/>
                <c:pt idx="0">
                  <c:v>Δpdr-1</c:v>
                </c:pt>
              </c:strCache>
            </c:strRef>
          </c:tx>
          <c:spPr>
            <a:solidFill>
              <a:srgbClr val="9DC3E6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47:$P$49</c:f>
                <c:numCache>
                  <c:formatCode>General</c:formatCode>
                  <c:ptCount val="2"/>
                  <c:pt idx="0">
                    <c:v>4.2943408452120817</c:v>
                  </c:pt>
                </c:numCache>
              </c:numRef>
            </c:plus>
            <c:minus>
              <c:numRef>
                <c:f>Sheet1!$P$47:$P$49</c:f>
                <c:numCache>
                  <c:formatCode>General</c:formatCode>
                  <c:ptCount val="2"/>
                  <c:pt idx="0">
                    <c:v>4.2943408452120817</c:v>
                  </c:pt>
                </c:numCache>
              </c:numRef>
            </c:minus>
          </c:errBars>
          <c:cat>
            <c:strRef>
              <c:f>Sheet1!$A$10:$A$11</c:f>
              <c:strCache>
                <c:ptCount val="1"/>
                <c:pt idx="0">
                  <c:v>1% xylan</c:v>
                </c:pt>
              </c:strCache>
            </c:strRef>
          </c:cat>
          <c:val>
            <c:numRef>
              <c:f>Sheet1!$P$43:$P$44</c:f>
              <c:numCache>
                <c:formatCode>#,#00</c:formatCode>
                <c:ptCount val="1"/>
                <c:pt idx="0">
                  <c:v>104.1322314049585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73B-4195-A1A1-BDE92F6B96EB}"/>
            </c:ext>
          </c:extLst>
        </c:ser>
        <c:ser>
          <c:idx val="2"/>
          <c:order val="2"/>
          <c:tx>
            <c:strRef>
              <c:f>Sheet1!$I$1</c:f>
              <c:strCache>
                <c:ptCount val="1"/>
                <c:pt idx="0">
                  <c:v>pdr-1-oex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473B-4195-A1A1-BDE92F6B96E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Q$47:$Q$49</c:f>
                <c:numCache>
                  <c:formatCode>General</c:formatCode>
                  <c:ptCount val="2"/>
                  <c:pt idx="0">
                    <c:v>10.754391898591292</c:v>
                  </c:pt>
                </c:numCache>
              </c:numRef>
            </c:plus>
            <c:minus>
              <c:numRef>
                <c:f>Sheet1!$Q$47:$Q$49</c:f>
                <c:numCache>
                  <c:formatCode>General</c:formatCode>
                  <c:ptCount val="2"/>
                  <c:pt idx="0">
                    <c:v>10.754391898591292</c:v>
                  </c:pt>
                </c:numCache>
              </c:numRef>
            </c:minus>
          </c:errBars>
          <c:cat>
            <c:strRef>
              <c:f>Sheet1!$A$10:$A$11</c:f>
              <c:strCache>
                <c:ptCount val="1"/>
                <c:pt idx="0">
                  <c:v>1% xylan</c:v>
                </c:pt>
              </c:strCache>
            </c:strRef>
          </c:cat>
          <c:val>
            <c:numRef>
              <c:f>Sheet1!$Q$43:$Q$44</c:f>
              <c:numCache>
                <c:formatCode>#,#00</c:formatCode>
                <c:ptCount val="1"/>
                <c:pt idx="0">
                  <c:v>104.407713498622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73B-4195-A1A1-BDE92F6B96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41707608"/>
        <c:axId val="441489264"/>
      </c:barChart>
      <c:catAx>
        <c:axId val="44170760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12700" cap="flat" cmpd="sng" algn="ctr">
            <a:solidFill>
              <a:schemeClr val="bg1">
                <a:lumMod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489264"/>
        <c:crosses val="autoZero"/>
        <c:auto val="1"/>
        <c:lblAlgn val="ctr"/>
        <c:lblOffset val="100"/>
        <c:noMultiLvlLbl val="0"/>
      </c:catAx>
      <c:valAx>
        <c:axId val="441489264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biomass accumulation [%]</a:t>
                </a:r>
              </a:p>
            </c:rich>
          </c:tx>
          <c:layout>
            <c:manualLayout>
              <c:xMode val="edge"/>
              <c:yMode val="edge"/>
              <c:x val="8.6989291164742549E-2"/>
              <c:y val="0.1198642879868983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00" sourceLinked="1"/>
        <c:majorTickMark val="cross"/>
        <c:minorTickMark val="none"/>
        <c:tickLblPos val="nextTo"/>
        <c:spPr>
          <a:noFill/>
          <a:ln w="12700"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17076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70293237367606"/>
          <c:y val="3.7453703703703704E-2"/>
          <c:w val="0.70544390665704271"/>
          <c:h val="0.77638086905803438"/>
        </c:manualLayout>
      </c:layout>
      <c:scatterChart>
        <c:scatterStyle val="lineMarker"/>
        <c:varyColors val="0"/>
        <c:ser>
          <c:idx val="0"/>
          <c:order val="0"/>
          <c:tx>
            <c:strRef>
              <c:f>correlation!$B$1</c:f>
              <c:strCache>
                <c:ptCount val="1"/>
                <c:pt idx="0">
                  <c:v>WT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bg1">
                    <a:lumMod val="65000"/>
                  </a:schemeClr>
                </a:solidFill>
                <a:prstDash val="sysDot"/>
              </a:ln>
              <a:effectLst/>
            </c:spPr>
            <c:trendlineType val="power"/>
            <c:dispRSqr val="0"/>
            <c:dispEq val="0"/>
          </c:trendline>
          <c:xVal>
            <c:numRef>
              <c:f>correlation!$B$2:$B$9</c:f>
              <c:numCache>
                <c:formatCode>General</c:formatCode>
                <c:ptCount val="8"/>
                <c:pt idx="0">
                  <c:v>18.433303779260541</c:v>
                </c:pt>
                <c:pt idx="1">
                  <c:v>4.2028177606450692</c:v>
                </c:pt>
                <c:pt idx="2">
                  <c:v>12.392069752206504</c:v>
                </c:pt>
                <c:pt idx="3">
                  <c:v>6.3484187292547709</c:v>
                </c:pt>
                <c:pt idx="4">
                  <c:v>32.164410033418342</c:v>
                </c:pt>
                <c:pt idx="5">
                  <c:v>7.3392062188561527</c:v>
                </c:pt>
                <c:pt idx="6">
                  <c:v>24.751370666375713</c:v>
                </c:pt>
                <c:pt idx="7">
                  <c:v>132.09559567231068</c:v>
                </c:pt>
              </c:numCache>
            </c:numRef>
          </c:xVal>
          <c:yVal>
            <c:numRef>
              <c:f>correlation!$F$2:$F$9</c:f>
              <c:numCache>
                <c:formatCode>0.0</c:formatCode>
                <c:ptCount val="8"/>
                <c:pt idx="0">
                  <c:v>12.746622085571289</c:v>
                </c:pt>
                <c:pt idx="1">
                  <c:v>12.029617547988892</c:v>
                </c:pt>
                <c:pt idx="2">
                  <c:v>17.681687593460083</c:v>
                </c:pt>
                <c:pt idx="3">
                  <c:v>23.869560718536377</c:v>
                </c:pt>
                <c:pt idx="4">
                  <c:v>53.315153121948242</c:v>
                </c:pt>
                <c:pt idx="5">
                  <c:v>13.193082809448242</c:v>
                </c:pt>
                <c:pt idx="6">
                  <c:v>21.010995864868164</c:v>
                </c:pt>
                <c:pt idx="7">
                  <c:v>74.393249511718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23-4FE3-9EDF-7BFD30474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1087216"/>
        <c:axId val="401087608"/>
      </c:scatterChart>
      <c:valAx>
        <c:axId val="401087216"/>
        <c:scaling>
          <c:logBase val="10"/>
          <c:orientation val="minMax"/>
          <c:max val="2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</a:t>
                </a:r>
                <a:r>
                  <a:rPr lang="en-US" sz="9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C</a:t>
                </a: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RNA-Seq)</a:t>
                </a:r>
                <a:endParaRPr lang="en-US" sz="9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25311251815448288"/>
              <c:y val="0.905092592592592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out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087608"/>
        <c:crosses val="autoZero"/>
        <c:crossBetween val="midCat"/>
        <c:majorUnit val="10"/>
      </c:valAx>
      <c:valAx>
        <c:axId val="401087608"/>
        <c:scaling>
          <c:logBase val="10"/>
          <c:orientation val="minMax"/>
          <c:max val="2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</a:t>
                </a:r>
                <a:r>
                  <a:rPr lang="en-US" sz="900" b="0" i="0" baseline="0" dirty="0" err="1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C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qPCR)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1490739476938393E-2"/>
              <c:y val="7.327100526844719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cross"/>
        <c:minorTickMark val="out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0872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22030885457171"/>
          <c:y val="3.7453703703703718E-2"/>
          <c:w val="0.64973050380023134"/>
          <c:h val="0.77638086905803438"/>
        </c:manualLayout>
      </c:layout>
      <c:scatterChart>
        <c:scatterStyle val="lineMarker"/>
        <c:varyColors val="0"/>
        <c:ser>
          <c:idx val="0"/>
          <c:order val="0"/>
          <c:tx>
            <c:strRef>
              <c:f>correlation!$C$1</c:f>
              <c:strCache>
                <c:ptCount val="1"/>
                <c:pt idx="0">
                  <c:v>Δpdr-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bg1">
                    <a:lumMod val="65000"/>
                  </a:schemeClr>
                </a:solidFill>
                <a:prstDash val="sysDot"/>
              </a:ln>
              <a:effectLst/>
            </c:spPr>
            <c:trendlineType val="power"/>
            <c:dispRSqr val="0"/>
            <c:dispEq val="0"/>
          </c:trendline>
          <c:xVal>
            <c:numRef>
              <c:f>correlation!$C$2:$C$9</c:f>
              <c:numCache>
                <c:formatCode>General</c:formatCode>
                <c:ptCount val="8"/>
                <c:pt idx="0">
                  <c:v>2.3778015790387692</c:v>
                </c:pt>
                <c:pt idx="1">
                  <c:v>2.2766600621573865</c:v>
                </c:pt>
                <c:pt idx="2">
                  <c:v>6.0982435909248069</c:v>
                </c:pt>
                <c:pt idx="3">
                  <c:v>35.655981535981283</c:v>
                </c:pt>
                <c:pt idx="4">
                  <c:v>40.971321527083006</c:v>
                </c:pt>
                <c:pt idx="5">
                  <c:v>6.2067420003259643</c:v>
                </c:pt>
                <c:pt idx="6">
                  <c:v>18.648855851743836</c:v>
                </c:pt>
                <c:pt idx="7">
                  <c:v>730.28315160285035</c:v>
                </c:pt>
              </c:numCache>
            </c:numRef>
          </c:xVal>
          <c:yVal>
            <c:numRef>
              <c:f>correlation!$G$2:$G$9</c:f>
              <c:numCache>
                <c:formatCode>0.0</c:formatCode>
                <c:ptCount val="8"/>
                <c:pt idx="0">
                  <c:v>3.0404165387153625</c:v>
                </c:pt>
                <c:pt idx="1">
                  <c:v>0.632313072681427</c:v>
                </c:pt>
                <c:pt idx="2">
                  <c:v>3.3149822354316711</c:v>
                </c:pt>
                <c:pt idx="3">
                  <c:v>38.334372520446777</c:v>
                </c:pt>
                <c:pt idx="4">
                  <c:v>74.768888473510742</c:v>
                </c:pt>
                <c:pt idx="5">
                  <c:v>23.423552513122559</c:v>
                </c:pt>
                <c:pt idx="6">
                  <c:v>32.525321960449219</c:v>
                </c:pt>
                <c:pt idx="7">
                  <c:v>767.505554199218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15E-4253-B845-84D0931B40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1089568"/>
        <c:axId val="401089960"/>
      </c:scatterChart>
      <c:valAx>
        <c:axId val="401089568"/>
        <c:scaling>
          <c:logBase val="10"/>
          <c:orientation val="minMax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-change over </a:t>
                </a:r>
                <a:r>
                  <a:rPr lang="en-US" sz="9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C</a:t>
                </a: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RNA-Seq)</a:t>
                </a:r>
                <a:endParaRPr lang="en-US" sz="9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28082592110072824"/>
              <c:y val="0.905092592592592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out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089960"/>
        <c:crosses val="autoZero"/>
        <c:crossBetween val="midCat"/>
        <c:majorUnit val="10"/>
      </c:valAx>
      <c:valAx>
        <c:axId val="401089960"/>
        <c:scaling>
          <c:logBase val="10"/>
          <c:orientation val="minMax"/>
          <c:max val="1000"/>
          <c:min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</a:t>
                </a:r>
                <a:r>
                  <a:rPr lang="en-US" sz="9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C</a:t>
                </a:r>
                <a:r>
                  <a:rPr lang="en-US" sz="9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(qPCR)</a:t>
                </a:r>
                <a:endParaRPr lang="en-US" sz="9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9047735090399557E-2"/>
              <c:y val="7.159095732889343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cross"/>
        <c:minorTickMark val="out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0895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805467560661428"/>
          <c:y val="5.0925925925925923E-2"/>
          <c:w val="0.68184803790569815"/>
          <c:h val="0.76328058002650656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5701040"/>
        <c:axId val="115701432"/>
      </c:barChart>
      <c:catAx>
        <c:axId val="115701040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1432"/>
        <c:crosses val="autoZero"/>
        <c:auto val="1"/>
        <c:lblAlgn val="ctr"/>
        <c:lblOffset val="100"/>
        <c:noMultiLvlLbl val="0"/>
      </c:catAx>
      <c:valAx>
        <c:axId val="115701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-change over pdr-1-oex on xylan</a:t>
                </a:r>
                <a:endParaRPr lang="en-US" sz="90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1193260808859074E-2"/>
              <c:y val="6.627024391955335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1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16489377422941"/>
          <c:y val="5.6814614678758701E-2"/>
          <c:w val="0.63007551514059512"/>
          <c:h val="0.763280580026506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CU09034!$AD$30</c:f>
              <c:strCache>
                <c:ptCount val="1"/>
                <c:pt idx="0">
                  <c:v>NCU09034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7F7F7F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'NCU09034'!$AB$3,'NCU09034'!$AB$7)</c:f>
                <c:numCache>
                  <c:formatCode>General</c:formatCode>
                  <c:ptCount val="2"/>
                  <c:pt idx="0">
                    <c:v>0.48870811862439617</c:v>
                  </c:pt>
                  <c:pt idx="1">
                    <c:v>7.268749396391371</c:v>
                  </c:pt>
                </c:numCache>
              </c:numRef>
            </c:plus>
            <c:minus>
              <c:numRef>
                <c:f>('NCU09034'!$AB$3,'NCU09034'!$AB$7)</c:f>
                <c:numCache>
                  <c:formatCode>General</c:formatCode>
                  <c:ptCount val="2"/>
                  <c:pt idx="0">
                    <c:v>0.48870811862439617</c:v>
                  </c:pt>
                  <c:pt idx="1">
                    <c:v>7.26874939639137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NCU09034'!$AD$31:$AD$32</c:f>
              <c:strCache>
                <c:ptCount val="2"/>
                <c:pt idx="0">
                  <c:v>WT on xylan</c:v>
                </c:pt>
                <c:pt idx="1">
                  <c:v>WT on xylan + L-Rha</c:v>
                </c:pt>
              </c:strCache>
            </c:strRef>
          </c:cat>
          <c:val>
            <c:numRef>
              <c:f>('NCU09034'!$AA$3,'NCU09034'!$AA$7)</c:f>
              <c:numCache>
                <c:formatCode>General</c:formatCode>
                <c:ptCount val="2"/>
                <c:pt idx="0">
                  <c:v>1.0911946646084569</c:v>
                </c:pt>
                <c:pt idx="1">
                  <c:v>27.6301776659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5702216"/>
        <c:axId val="115702608"/>
      </c:barChart>
      <c:catAx>
        <c:axId val="11570221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2608"/>
        <c:crosses val="autoZero"/>
        <c:auto val="1"/>
        <c:lblAlgn val="ctr"/>
        <c:lblOffset val="100"/>
        <c:noMultiLvlLbl val="0"/>
      </c:catAx>
      <c:valAx>
        <c:axId val="1157026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WT </a:t>
                </a: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n xylan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4040119985001867E-2"/>
              <c:y val="0.1300963216918459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22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805467560661428"/>
          <c:y val="5.0925925925925923E-2"/>
          <c:w val="0.66674765063910624"/>
          <c:h val="0.763280580026506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CU09034!$AD$30</c:f>
              <c:strCache>
                <c:ptCount val="1"/>
                <c:pt idx="0">
                  <c:v>NCU09034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DC3E6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2F5597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'NCU09034'!$AB$25,'NCU09034'!$AB$28)</c:f>
                <c:numCache>
                  <c:formatCode>General</c:formatCode>
                  <c:ptCount val="2"/>
                  <c:pt idx="0">
                    <c:v>0.70729998829464302</c:v>
                  </c:pt>
                  <c:pt idx="1">
                    <c:v>30.129738543118968</c:v>
                  </c:pt>
                </c:numCache>
              </c:numRef>
            </c:plus>
            <c:minus>
              <c:numRef>
                <c:f>('NCU09034'!$AB$25,'NCU09034'!$AB$28)</c:f>
                <c:numCache>
                  <c:formatCode>General</c:formatCode>
                  <c:ptCount val="2"/>
                  <c:pt idx="0">
                    <c:v>0.70729998829464302</c:v>
                  </c:pt>
                  <c:pt idx="1">
                    <c:v>30.12973854311896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NCU09034'!$AD$33:$AD$34</c:f>
              <c:strCache>
                <c:ptCount val="2"/>
                <c:pt idx="0">
                  <c:v>pdr-1-oex on xylan</c:v>
                </c:pt>
                <c:pt idx="1">
                  <c:v>pdr-1-oex on xylan + L-Rha</c:v>
                </c:pt>
              </c:strCache>
            </c:strRef>
          </c:cat>
          <c:val>
            <c:numRef>
              <c:f>('NCU09034'!$AA$25,'NCU09034'!$AA$28)</c:f>
              <c:numCache>
                <c:formatCode>General</c:formatCode>
                <c:ptCount val="2"/>
                <c:pt idx="0">
                  <c:v>1.177037976817968</c:v>
                </c:pt>
                <c:pt idx="1">
                  <c:v>95.4705776995835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5703392"/>
        <c:axId val="115703784"/>
      </c:barChart>
      <c:catAx>
        <c:axId val="115703392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3784"/>
        <c:crosses val="autoZero"/>
        <c:auto val="1"/>
        <c:lblAlgn val="ctr"/>
        <c:lblOffset val="100"/>
        <c:noMultiLvlLbl val="0"/>
      </c:catAx>
      <c:valAx>
        <c:axId val="1157037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pdr-1-oex on xylan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1193332016293669E-2"/>
              <c:y val="6.6270203066721919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57033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207575851812994"/>
          <c:y val="3.3901342085449308E-2"/>
          <c:w val="0.65310845730475586"/>
          <c:h val="0.661132695989830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dr-1'!$AD$25</c:f>
              <c:strCache>
                <c:ptCount val="1"/>
                <c:pt idx="0">
                  <c:v>pdr-1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DC3E6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2F5597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'pdr-1'!$AB$29,'pdr-1'!$AB$34)</c:f>
                <c:numCache>
                  <c:formatCode>General</c:formatCode>
                  <c:ptCount val="2"/>
                  <c:pt idx="0">
                    <c:v>0.22938485936696668</c:v>
                  </c:pt>
                  <c:pt idx="1">
                    <c:v>0.15557105823206407</c:v>
                  </c:pt>
                </c:numCache>
              </c:numRef>
            </c:plus>
            <c:minus>
              <c:numRef>
                <c:f>('pdr-1'!$AB$29,'pdr-1'!$AB$34)</c:f>
                <c:numCache>
                  <c:formatCode>General</c:formatCode>
                  <c:ptCount val="2"/>
                  <c:pt idx="0">
                    <c:v>0.22938485936696668</c:v>
                  </c:pt>
                  <c:pt idx="1">
                    <c:v>0.1555710582320640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pdr-1'!$AD$22:$AD$23</c:f>
              <c:strCache>
                <c:ptCount val="2"/>
                <c:pt idx="0">
                  <c:v>pdr-1-oex on xylan</c:v>
                </c:pt>
                <c:pt idx="1">
                  <c:v>pdr-1-oex on xylan + L-Rha</c:v>
                </c:pt>
              </c:strCache>
            </c:strRef>
          </c:cat>
          <c:val>
            <c:numRef>
              <c:f>('pdr-1'!$AA$29,'pdr-1'!$AA$34)</c:f>
              <c:numCache>
                <c:formatCode>General</c:formatCode>
                <c:ptCount val="2"/>
                <c:pt idx="0">
                  <c:v>1.0214623395338045</c:v>
                </c:pt>
                <c:pt idx="1">
                  <c:v>1.1924374684507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01620800"/>
        <c:axId val="401621192"/>
      </c:barChart>
      <c:catAx>
        <c:axId val="401620800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1192"/>
        <c:crosses val="autoZero"/>
        <c:auto val="1"/>
        <c:lblAlgn val="ctr"/>
        <c:lblOffset val="100"/>
        <c:noMultiLvlLbl val="0"/>
      </c:catAx>
      <c:valAx>
        <c:axId val="401621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pdr-1-oex on xylan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184232434393238E-2"/>
              <c:y val="1.5196598650094841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08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88835363702703"/>
          <c:y val="6.2725477899333373E-2"/>
          <c:w val="0.72201468510454836"/>
          <c:h val="0.710183262490418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dr-1'!$AD$25</c:f>
              <c:strCache>
                <c:ptCount val="1"/>
                <c:pt idx="0">
                  <c:v>pdr-1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7F7F7F"/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'pdr-1'!$AB$4,'pdr-1'!$AB$8)</c:f>
                <c:numCache>
                  <c:formatCode>General</c:formatCode>
                  <c:ptCount val="2"/>
                  <c:pt idx="0">
                    <c:v>0.25991630804688226</c:v>
                  </c:pt>
                  <c:pt idx="1">
                    <c:v>3.0603629555979599</c:v>
                  </c:pt>
                </c:numCache>
              </c:numRef>
            </c:plus>
            <c:minus>
              <c:numRef>
                <c:f>('pdr-1'!$AB$4,'pdr-1'!$AB$8)</c:f>
                <c:numCache>
                  <c:formatCode>General</c:formatCode>
                  <c:ptCount val="2"/>
                  <c:pt idx="0">
                    <c:v>0.25991630804688226</c:v>
                  </c:pt>
                  <c:pt idx="1">
                    <c:v>3.060362955597959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pdr-1'!$AD$20:$AD$21</c:f>
              <c:strCache>
                <c:ptCount val="2"/>
                <c:pt idx="0">
                  <c:v>WT on xylan</c:v>
                </c:pt>
                <c:pt idx="1">
                  <c:v>WT on xylan + L-Rha</c:v>
                </c:pt>
              </c:strCache>
            </c:strRef>
          </c:cat>
          <c:val>
            <c:numRef>
              <c:f>('pdr-1'!$AA$4,'pdr-1'!$AA$8)</c:f>
              <c:numCache>
                <c:formatCode>General</c:formatCode>
                <c:ptCount val="2"/>
                <c:pt idx="0">
                  <c:v>1.0273953402381173</c:v>
                </c:pt>
                <c:pt idx="1">
                  <c:v>12.0897295605811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01621976"/>
        <c:axId val="401622368"/>
      </c:barChart>
      <c:catAx>
        <c:axId val="40162197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2368"/>
        <c:crosses val="autoZero"/>
        <c:auto val="1"/>
        <c:lblAlgn val="ctr"/>
        <c:lblOffset val="100"/>
        <c:noMultiLvlLbl val="0"/>
      </c:catAx>
      <c:valAx>
        <c:axId val="4016223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WT on xylan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118194059263144E-2"/>
              <c:y val="4.8571295844656588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197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88835363702703"/>
          <c:y val="5.9248555860274769E-2"/>
          <c:w val="0.70601478467812495"/>
          <c:h val="0.770779720772348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dr-1'!$M$43</c:f>
              <c:strCache>
                <c:ptCount val="1"/>
                <c:pt idx="0">
                  <c:v>pdr-1</c:v>
                </c:pt>
              </c:strCache>
            </c:strRef>
          </c:tx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165-4EFC-A0A5-4844DE52FC29}"/>
              </c:ext>
            </c:extLst>
          </c:dPt>
          <c:dPt>
            <c:idx val="1"/>
            <c:invertIfNegative val="0"/>
            <c:bubble3D val="0"/>
            <c:spPr>
              <a:solidFill>
                <a:srgbClr val="9DC3E6"/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165-4EFC-A0A5-4844DE52FC2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165-4EFC-A0A5-4844DE52FC29}"/>
              </c:ext>
            </c:extLst>
          </c:dPt>
          <c:errBars>
            <c:errBarType val="both"/>
            <c:errValType val="cust"/>
            <c:noEndCap val="0"/>
            <c:plus>
              <c:numRef>
                <c:f>('pdr-1'!$J$46,'pdr-1'!$J$44)</c:f>
                <c:numCache>
                  <c:formatCode>General</c:formatCode>
                  <c:ptCount val="2"/>
                  <c:pt idx="0">
                    <c:v>9.8026599295389615E-3</c:v>
                  </c:pt>
                  <c:pt idx="1">
                    <c:v>2.6913328187221541</c:v>
                  </c:pt>
                </c:numCache>
              </c:numRef>
            </c:plus>
            <c:minus>
              <c:numRef>
                <c:f>('pdr-1'!$J$46,'pdr-1'!$J$44)</c:f>
                <c:numCache>
                  <c:formatCode>General</c:formatCode>
                  <c:ptCount val="2"/>
                  <c:pt idx="0">
                    <c:v>9.8026599295389615E-3</c:v>
                  </c:pt>
                  <c:pt idx="1">
                    <c:v>2.691332818722154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pdr-1'!$N$42:$N$44</c:f>
              <c:strCache>
                <c:ptCount val="3"/>
                <c:pt idx="0">
                  <c:v>WT</c:v>
                </c:pt>
                <c:pt idx="1">
                  <c:v>pdr-1-oex</c:v>
                </c:pt>
                <c:pt idx="2">
                  <c:v>gh28-1-comp</c:v>
                </c:pt>
              </c:strCache>
            </c:strRef>
          </c:cat>
          <c:val>
            <c:numRef>
              <c:f>('pdr-1'!$I$46,'pdr-1'!$I$44)</c:f>
              <c:numCache>
                <c:formatCode>General</c:formatCode>
                <c:ptCount val="2"/>
                <c:pt idx="0">
                  <c:v>1.0000240227468773</c:v>
                </c:pt>
                <c:pt idx="1">
                  <c:v>33.488415840630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165-4EFC-A0A5-4844DE52FC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01623152"/>
        <c:axId val="401623544"/>
      </c:barChart>
      <c:catAx>
        <c:axId val="401623152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3544"/>
        <c:crosses val="autoZero"/>
        <c:auto val="1"/>
        <c:lblAlgn val="ctr"/>
        <c:lblOffset val="100"/>
        <c:noMultiLvlLbl val="0"/>
      </c:catAx>
      <c:valAx>
        <c:axId val="4016235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fold change </a:t>
                </a:r>
                <a:r>
                  <a:rPr lang="en-US" sz="900" b="0" i="0" baseline="0" dirty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over WT</a:t>
                </a:r>
                <a:endParaRPr lang="en-US" sz="900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6666883639636174E-2"/>
              <c:y val="9.828177220005519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623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3456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7741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2530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808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2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0455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12624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2563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647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3776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1315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2951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7FE12-8DFC-4437-BFC8-FDFCF802AD9B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30.03.2017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42A04-912D-4FFF-9425-502D54A0D244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4701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33039" rtl="0" eaLnBrk="1" latinLnBrk="0" hangingPunct="1">
        <a:lnSpc>
          <a:spcPct val="90000"/>
        </a:lnSpc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0" indent="-158260" algn="l" defTabSz="633039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sz="1938" kern="1200">
          <a:solidFill>
            <a:schemeClr val="tx1"/>
          </a:solidFill>
          <a:latin typeface="+mn-lt"/>
          <a:ea typeface="+mn-ea"/>
          <a:cs typeface="+mn-cs"/>
        </a:defRPr>
      </a:lvl1pPr>
      <a:lvl2pPr marL="47477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image" Target="../media/image14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1943" y="24613"/>
            <a:ext cx="2736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619876" y="3550583"/>
            <a:ext cx="560758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: Schematic depiction of phylogeny and conserved domains/signals in the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gene and its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rtholog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amino acid sequence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. cras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CU09033)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. nig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R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n13g00910)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. nidulan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R (AN5673)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stipiti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RC1 (ABN68604) was used in a conserved domain search, as well as NLS and NES prediction. The phylogeny of these proteins was determined.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. cinere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GaaR (Bcin09g00170) constitutes the outgroup in the phylogenetic tree. GAL4 = GAL4-like Zn(II)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ys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r C6 zinc) binuclear cluster DNA-binding domain, fungal TF MHR = fungal transcription factor regulatory middle homology region, green triangle = nuclear localization signal, red triangle = nuclear export signal</a:t>
            </a:r>
          </a:p>
        </p:txBody>
      </p:sp>
      <p:grpSp>
        <p:nvGrpSpPr>
          <p:cNvPr id="87" name="Gruppieren 86"/>
          <p:cNvGrpSpPr/>
          <p:nvPr/>
        </p:nvGrpSpPr>
        <p:grpSpPr>
          <a:xfrm>
            <a:off x="736856" y="704528"/>
            <a:ext cx="5373622" cy="2860690"/>
            <a:chOff x="736856" y="704528"/>
            <a:chExt cx="5373622" cy="2860690"/>
          </a:xfrm>
        </p:grpSpPr>
        <p:grpSp>
          <p:nvGrpSpPr>
            <p:cNvPr id="80" name="Gruppieren 79"/>
            <p:cNvGrpSpPr/>
            <p:nvPr/>
          </p:nvGrpSpPr>
          <p:grpSpPr>
            <a:xfrm>
              <a:off x="736856" y="704528"/>
              <a:ext cx="5373622" cy="2693356"/>
              <a:chOff x="1017180" y="711290"/>
              <a:chExt cx="5373622" cy="2693356"/>
            </a:xfrm>
          </p:grpSpPr>
          <p:grpSp>
            <p:nvGrpSpPr>
              <p:cNvPr id="5" name="Gruppieren 4"/>
              <p:cNvGrpSpPr/>
              <p:nvPr/>
            </p:nvGrpSpPr>
            <p:grpSpPr>
              <a:xfrm>
                <a:off x="1954811" y="2404145"/>
                <a:ext cx="4006802" cy="420617"/>
                <a:chOff x="1801981" y="1901135"/>
                <a:chExt cx="4006802" cy="420617"/>
              </a:xfrm>
            </p:grpSpPr>
            <p:sp>
              <p:nvSpPr>
                <p:cNvPr id="46" name="Rechteck: abgerundete Ecken 45"/>
                <p:cNvSpPr/>
                <p:nvPr/>
              </p:nvSpPr>
              <p:spPr>
                <a:xfrm>
                  <a:off x="3041057" y="2153857"/>
                  <a:ext cx="2582955" cy="72008"/>
                </a:xfrm>
                <a:prstGeom prst="round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48" name="Textfeld 47"/>
                <p:cNvSpPr txBox="1"/>
                <p:nvPr/>
              </p:nvSpPr>
              <p:spPr>
                <a:xfrm>
                  <a:off x="1801981" y="2075531"/>
                  <a:ext cx="12581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. </a:t>
                  </a:r>
                  <a:r>
                    <a:rPr lang="de-DE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idulans </a:t>
                  </a:r>
                  <a:r>
                    <a:rPr lang="de-DE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haR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Textfeld 53"/>
                <p:cNvSpPr txBox="1"/>
                <p:nvPr/>
              </p:nvSpPr>
              <p:spPr>
                <a:xfrm>
                  <a:off x="2945646" y="1948575"/>
                  <a:ext cx="1908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Textfeld 54"/>
                <p:cNvSpPr txBox="1"/>
                <p:nvPr/>
              </p:nvSpPr>
              <p:spPr>
                <a:xfrm>
                  <a:off x="5427141" y="1936851"/>
                  <a:ext cx="38164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30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Rechteck: abgerundete Ecken 61"/>
                <p:cNvSpPr/>
                <p:nvPr/>
              </p:nvSpPr>
              <p:spPr>
                <a:xfrm>
                  <a:off x="3901055" y="2102631"/>
                  <a:ext cx="1359450" cy="149034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1">
                        <a:lumMod val="60000"/>
                        <a:lumOff val="40000"/>
                        <a:shade val="30000"/>
                        <a:satMod val="115000"/>
                      </a:schemeClr>
                    </a:gs>
                    <a:gs pos="50000">
                      <a:schemeClr val="accent1">
                        <a:lumMod val="60000"/>
                        <a:lumOff val="40000"/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lumMod val="60000"/>
                        <a:lumOff val="40000"/>
                        <a:shade val="100000"/>
                        <a:satMod val="115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" name="Textfeld 66"/>
                <p:cNvSpPr txBox="1"/>
                <p:nvPr/>
              </p:nvSpPr>
              <p:spPr>
                <a:xfrm>
                  <a:off x="3899752" y="1901135"/>
                  <a:ext cx="135945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ungal</a:t>
                  </a:r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F MHR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hteck: obere Ecken abgeschnitten 27"/>
                <p:cNvSpPr/>
                <p:nvPr/>
              </p:nvSpPr>
              <p:spPr>
                <a:xfrm rot="10800000">
                  <a:off x="3203902" y="2134742"/>
                  <a:ext cx="155737" cy="153541"/>
                </a:xfrm>
                <a:prstGeom prst="snip2SameRect">
                  <a:avLst>
                    <a:gd name="adj1" fmla="val 30625"/>
                    <a:gd name="adj2" fmla="val 0"/>
                  </a:avLst>
                </a:prstGeom>
                <a:gradFill flip="none" rotWithShape="1">
                  <a:gsLst>
                    <a:gs pos="0">
                      <a:schemeClr val="accent2">
                        <a:tint val="66000"/>
                        <a:satMod val="160000"/>
                      </a:schemeClr>
                    </a:gs>
                    <a:gs pos="50000">
                      <a:schemeClr val="accent2">
                        <a:tint val="44500"/>
                        <a:satMod val="160000"/>
                      </a:schemeClr>
                    </a:gs>
                    <a:gs pos="100000">
                      <a:schemeClr val="accent2">
                        <a:tint val="23500"/>
                        <a:satMod val="160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Textfeld 28"/>
                <p:cNvSpPr txBox="1"/>
                <p:nvPr/>
              </p:nvSpPr>
              <p:spPr>
                <a:xfrm>
                  <a:off x="3040800" y="1947149"/>
                  <a:ext cx="48252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L4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Gleichschenkliges Dreieck 31"/>
                <p:cNvSpPr/>
                <p:nvPr/>
              </p:nvSpPr>
              <p:spPr>
                <a:xfrm>
                  <a:off x="3075128" y="2133983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92D050">
                        <a:shade val="30000"/>
                        <a:satMod val="115000"/>
                      </a:srgbClr>
                    </a:gs>
                    <a:gs pos="50000">
                      <a:srgbClr val="92D050">
                        <a:shade val="67500"/>
                        <a:satMod val="115000"/>
                      </a:srgbClr>
                    </a:gs>
                    <a:gs pos="100000">
                      <a:srgbClr val="92D050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Gleichschenkliges Dreieck 32"/>
                <p:cNvSpPr/>
                <p:nvPr/>
              </p:nvSpPr>
              <p:spPr>
                <a:xfrm rot="10800000">
                  <a:off x="4221100" y="2122463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C00000">
                        <a:shade val="30000"/>
                        <a:satMod val="115000"/>
                      </a:srgbClr>
                    </a:gs>
                    <a:gs pos="50000">
                      <a:srgbClr val="C00000">
                        <a:shade val="67500"/>
                        <a:satMod val="115000"/>
                      </a:srgbClr>
                    </a:gs>
                    <a:gs pos="100000">
                      <a:srgbClr val="C00000">
                        <a:shade val="100000"/>
                        <a:satMod val="115000"/>
                      </a:srgbClr>
                    </a:gs>
                  </a:gsLst>
                  <a:lin ang="54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4" name="Gleichschenkliges Dreieck 33"/>
                <p:cNvSpPr/>
                <p:nvPr/>
              </p:nvSpPr>
              <p:spPr>
                <a:xfrm rot="10800000">
                  <a:off x="3384303" y="2141514"/>
                  <a:ext cx="108000" cy="108000"/>
                </a:xfrm>
                <a:prstGeom prst="triangle">
                  <a:avLst/>
                </a:prstGeom>
                <a:solidFill>
                  <a:srgbClr val="C0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" name="Gruppieren 6"/>
              <p:cNvGrpSpPr/>
              <p:nvPr/>
            </p:nvGrpSpPr>
            <p:grpSpPr>
              <a:xfrm>
                <a:off x="1940788" y="1866181"/>
                <a:ext cx="4015671" cy="392963"/>
                <a:chOff x="1792007" y="1290117"/>
                <a:chExt cx="4015671" cy="392963"/>
              </a:xfrm>
            </p:grpSpPr>
            <p:sp>
              <p:nvSpPr>
                <p:cNvPr id="47" name="Rechteck: abgerundete Ecken 46"/>
                <p:cNvSpPr/>
                <p:nvPr/>
              </p:nvSpPr>
              <p:spPr>
                <a:xfrm>
                  <a:off x="3041057" y="1527710"/>
                  <a:ext cx="2575800" cy="72008"/>
                </a:xfrm>
                <a:prstGeom prst="round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49" name="Textfeld 48"/>
                <p:cNvSpPr txBox="1"/>
                <p:nvPr/>
              </p:nvSpPr>
              <p:spPr>
                <a:xfrm>
                  <a:off x="1792007" y="1436859"/>
                  <a:ext cx="125407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. niger </a:t>
                  </a:r>
                  <a:r>
                    <a:rPr lang="de-DE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haR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Textfeld 51"/>
                <p:cNvSpPr txBox="1"/>
                <p:nvPr/>
              </p:nvSpPr>
              <p:spPr>
                <a:xfrm>
                  <a:off x="2945646" y="1327655"/>
                  <a:ext cx="1908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Textfeld 52"/>
                <p:cNvSpPr txBox="1"/>
                <p:nvPr/>
              </p:nvSpPr>
              <p:spPr>
                <a:xfrm>
                  <a:off x="5426036" y="1327517"/>
                  <a:ext cx="38164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27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Rechteck: abgerundete Ecken 59"/>
                <p:cNvSpPr/>
                <p:nvPr/>
              </p:nvSpPr>
              <p:spPr>
                <a:xfrm>
                  <a:off x="3899752" y="1483832"/>
                  <a:ext cx="1359450" cy="149034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1">
                        <a:lumMod val="60000"/>
                        <a:lumOff val="40000"/>
                        <a:shade val="30000"/>
                        <a:satMod val="115000"/>
                      </a:schemeClr>
                    </a:gs>
                    <a:gs pos="50000">
                      <a:schemeClr val="accent1">
                        <a:lumMod val="60000"/>
                        <a:lumOff val="40000"/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lumMod val="60000"/>
                        <a:lumOff val="40000"/>
                        <a:shade val="100000"/>
                        <a:satMod val="115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" name="Textfeld 63"/>
                <p:cNvSpPr txBox="1"/>
                <p:nvPr/>
              </p:nvSpPr>
              <p:spPr>
                <a:xfrm>
                  <a:off x="3053394" y="1319036"/>
                  <a:ext cx="48252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L4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Textfeld 65"/>
                <p:cNvSpPr txBox="1"/>
                <p:nvPr/>
              </p:nvSpPr>
              <p:spPr>
                <a:xfrm>
                  <a:off x="3899752" y="1290117"/>
                  <a:ext cx="135945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ungal</a:t>
                  </a:r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F MHR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Rechteck: obere Ecken abgeschnitten 29"/>
                <p:cNvSpPr/>
                <p:nvPr/>
              </p:nvSpPr>
              <p:spPr>
                <a:xfrm rot="10800000">
                  <a:off x="3212920" y="1502096"/>
                  <a:ext cx="155737" cy="153541"/>
                </a:xfrm>
                <a:prstGeom prst="snip2SameRect">
                  <a:avLst>
                    <a:gd name="adj1" fmla="val 30625"/>
                    <a:gd name="adj2" fmla="val 0"/>
                  </a:avLst>
                </a:prstGeom>
                <a:gradFill flip="none" rotWithShape="1">
                  <a:gsLst>
                    <a:gs pos="0">
                      <a:schemeClr val="accent2">
                        <a:tint val="66000"/>
                        <a:satMod val="160000"/>
                      </a:schemeClr>
                    </a:gs>
                    <a:gs pos="50000">
                      <a:schemeClr val="accent2">
                        <a:tint val="44500"/>
                        <a:satMod val="160000"/>
                      </a:schemeClr>
                    </a:gs>
                    <a:gs pos="100000">
                      <a:schemeClr val="accent2">
                        <a:tint val="23500"/>
                        <a:satMod val="160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7" name="Gleichschenkliges Dreieck 36"/>
                <p:cNvSpPr/>
                <p:nvPr/>
              </p:nvSpPr>
              <p:spPr>
                <a:xfrm>
                  <a:off x="3081439" y="1505024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92D050">
                        <a:shade val="30000"/>
                        <a:satMod val="115000"/>
                      </a:srgbClr>
                    </a:gs>
                    <a:gs pos="50000">
                      <a:srgbClr val="92D050">
                        <a:shade val="67500"/>
                        <a:satMod val="115000"/>
                      </a:srgbClr>
                    </a:gs>
                    <a:gs pos="100000">
                      <a:srgbClr val="92D050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8" name="Gleichschenkliges Dreieck 37"/>
                <p:cNvSpPr/>
                <p:nvPr/>
              </p:nvSpPr>
              <p:spPr>
                <a:xfrm rot="10800000">
                  <a:off x="4221100" y="1503665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C00000">
                        <a:shade val="30000"/>
                        <a:satMod val="115000"/>
                      </a:srgbClr>
                    </a:gs>
                    <a:gs pos="50000">
                      <a:srgbClr val="C00000">
                        <a:shade val="67500"/>
                        <a:satMod val="115000"/>
                      </a:srgbClr>
                    </a:gs>
                    <a:gs pos="100000">
                      <a:srgbClr val="C00000">
                        <a:shade val="100000"/>
                        <a:satMod val="115000"/>
                      </a:srgbClr>
                    </a:gs>
                  </a:gsLst>
                  <a:lin ang="54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8" name="Gruppieren 7"/>
              <p:cNvGrpSpPr/>
              <p:nvPr/>
            </p:nvGrpSpPr>
            <p:grpSpPr>
              <a:xfrm>
                <a:off x="2048735" y="1280592"/>
                <a:ext cx="4342067" cy="401638"/>
                <a:chOff x="1895245" y="677792"/>
                <a:chExt cx="4342067" cy="401638"/>
              </a:xfrm>
            </p:grpSpPr>
            <p:sp>
              <p:nvSpPr>
                <p:cNvPr id="12" name="Rechteck: abgerundete Ecken 11"/>
                <p:cNvSpPr/>
                <p:nvPr/>
              </p:nvSpPr>
              <p:spPr>
                <a:xfrm>
                  <a:off x="3041057" y="920552"/>
                  <a:ext cx="3005434" cy="72008"/>
                </a:xfrm>
                <a:prstGeom prst="round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14" name="Textfeld 13"/>
                <p:cNvSpPr txBox="1"/>
                <p:nvPr/>
              </p:nvSpPr>
              <p:spPr>
                <a:xfrm>
                  <a:off x="1895245" y="833209"/>
                  <a:ext cx="117922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. </a:t>
                  </a:r>
                  <a:r>
                    <a:rPr lang="de-DE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rassa </a:t>
                  </a:r>
                  <a:r>
                    <a:rPr lang="de-DE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DR-1</a:t>
                  </a:r>
                  <a:endPara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feld 14"/>
                <p:cNvSpPr txBox="1"/>
                <p:nvPr/>
              </p:nvSpPr>
              <p:spPr>
                <a:xfrm>
                  <a:off x="2945646" y="725724"/>
                  <a:ext cx="1908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Textfeld 50"/>
                <p:cNvSpPr txBox="1"/>
                <p:nvPr/>
              </p:nvSpPr>
              <p:spPr>
                <a:xfrm>
                  <a:off x="5855670" y="725724"/>
                  <a:ext cx="38164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71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Rechteck: obere Ecken abgeschnitten 55"/>
                <p:cNvSpPr/>
                <p:nvPr/>
              </p:nvSpPr>
              <p:spPr>
                <a:xfrm rot="10800000">
                  <a:off x="3285894" y="894282"/>
                  <a:ext cx="155737" cy="153541"/>
                </a:xfrm>
                <a:prstGeom prst="snip2SameRect">
                  <a:avLst>
                    <a:gd name="adj1" fmla="val 30625"/>
                    <a:gd name="adj2" fmla="val 0"/>
                  </a:avLst>
                </a:prstGeom>
                <a:gradFill flip="none" rotWithShape="1">
                  <a:gsLst>
                    <a:gs pos="0">
                      <a:schemeClr val="accent2">
                        <a:tint val="66000"/>
                        <a:satMod val="160000"/>
                      </a:schemeClr>
                    </a:gs>
                    <a:gs pos="50000">
                      <a:schemeClr val="accent2">
                        <a:tint val="44500"/>
                        <a:satMod val="160000"/>
                      </a:schemeClr>
                    </a:gs>
                    <a:gs pos="100000">
                      <a:schemeClr val="accent2">
                        <a:tint val="23500"/>
                        <a:satMod val="160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Rechteck: abgerundete Ecken 56"/>
                <p:cNvSpPr/>
                <p:nvPr/>
              </p:nvSpPr>
              <p:spPr>
                <a:xfrm>
                  <a:off x="4066872" y="884758"/>
                  <a:ext cx="1359450" cy="149034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1">
                        <a:lumMod val="60000"/>
                        <a:lumOff val="40000"/>
                        <a:shade val="30000"/>
                        <a:satMod val="115000"/>
                      </a:schemeClr>
                    </a:gs>
                    <a:gs pos="50000">
                      <a:schemeClr val="accent1">
                        <a:lumMod val="60000"/>
                        <a:lumOff val="40000"/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lumMod val="60000"/>
                        <a:lumOff val="40000"/>
                        <a:shade val="100000"/>
                        <a:satMod val="115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" name="Textfeld 62"/>
                <p:cNvSpPr txBox="1"/>
                <p:nvPr/>
              </p:nvSpPr>
              <p:spPr>
                <a:xfrm>
                  <a:off x="3129522" y="716214"/>
                  <a:ext cx="48252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L4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feld 64"/>
                <p:cNvSpPr txBox="1"/>
                <p:nvPr/>
              </p:nvSpPr>
              <p:spPr>
                <a:xfrm>
                  <a:off x="4075696" y="677792"/>
                  <a:ext cx="135062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ungal</a:t>
                  </a:r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F MHR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Gleichschenkliges Dreieck 39"/>
                <p:cNvSpPr/>
                <p:nvPr/>
              </p:nvSpPr>
              <p:spPr>
                <a:xfrm>
                  <a:off x="3163852" y="895690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92D050">
                        <a:shade val="30000"/>
                        <a:satMod val="115000"/>
                      </a:srgbClr>
                    </a:gs>
                    <a:gs pos="50000">
                      <a:srgbClr val="92D050">
                        <a:shade val="67500"/>
                        <a:satMod val="115000"/>
                      </a:srgbClr>
                    </a:gs>
                    <a:gs pos="100000">
                      <a:srgbClr val="92D050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1" name="Gleichschenkliges Dreieck 40"/>
                <p:cNvSpPr/>
                <p:nvPr/>
              </p:nvSpPr>
              <p:spPr>
                <a:xfrm rot="10800000">
                  <a:off x="4398459" y="909042"/>
                  <a:ext cx="108000" cy="108000"/>
                </a:xfrm>
                <a:prstGeom prst="triangle">
                  <a:avLst/>
                </a:prstGeom>
                <a:gradFill flip="none" rotWithShape="1">
                  <a:gsLst>
                    <a:gs pos="0">
                      <a:srgbClr val="C00000">
                        <a:shade val="30000"/>
                        <a:satMod val="115000"/>
                      </a:srgbClr>
                    </a:gs>
                    <a:gs pos="50000">
                      <a:srgbClr val="C00000">
                        <a:shade val="67500"/>
                        <a:satMod val="115000"/>
                      </a:srgbClr>
                    </a:gs>
                    <a:gs pos="100000">
                      <a:srgbClr val="C00000">
                        <a:shade val="100000"/>
                        <a:satMod val="115000"/>
                      </a:srgbClr>
                    </a:gs>
                  </a:gsLst>
                  <a:lin ang="54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4" name="Gruppieren 3"/>
              <p:cNvGrpSpPr/>
              <p:nvPr/>
            </p:nvGrpSpPr>
            <p:grpSpPr>
              <a:xfrm>
                <a:off x="2353071" y="711290"/>
                <a:ext cx="3096259" cy="478244"/>
                <a:chOff x="2213871" y="2504728"/>
                <a:chExt cx="3096259" cy="478244"/>
              </a:xfrm>
            </p:grpSpPr>
            <p:sp>
              <p:nvSpPr>
                <p:cNvPr id="35" name="Rechteck: abgerundete Ecken 45"/>
                <p:cNvSpPr/>
                <p:nvPr/>
              </p:nvSpPr>
              <p:spPr>
                <a:xfrm>
                  <a:off x="3049199" y="2747925"/>
                  <a:ext cx="2074950" cy="72008"/>
                </a:xfrm>
                <a:prstGeom prst="round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36" name="Textfeld 35"/>
                <p:cNvSpPr txBox="1"/>
                <p:nvPr/>
              </p:nvSpPr>
              <p:spPr>
                <a:xfrm>
                  <a:off x="2213871" y="2582862"/>
                  <a:ext cx="81611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. </a:t>
                  </a:r>
                  <a:r>
                    <a:rPr lang="de-DE" sz="1000" b="1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tipitis</a:t>
                  </a:r>
                  <a:r>
                    <a:rPr lang="de-DE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RC1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Textfeld 38"/>
                <p:cNvSpPr txBox="1"/>
                <p:nvPr/>
              </p:nvSpPr>
              <p:spPr>
                <a:xfrm>
                  <a:off x="2953789" y="2542643"/>
                  <a:ext cx="1908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feld 41"/>
                <p:cNvSpPr txBox="1"/>
                <p:nvPr/>
              </p:nvSpPr>
              <p:spPr>
                <a:xfrm>
                  <a:off x="4928488" y="2530919"/>
                  <a:ext cx="38164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37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Rechteck: abgerundete Ecken 61"/>
                <p:cNvSpPr/>
                <p:nvPr/>
              </p:nvSpPr>
              <p:spPr>
                <a:xfrm>
                  <a:off x="3569626" y="2707169"/>
                  <a:ext cx="1359450" cy="149034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1">
                        <a:lumMod val="60000"/>
                        <a:lumOff val="40000"/>
                        <a:shade val="30000"/>
                        <a:satMod val="115000"/>
                      </a:schemeClr>
                    </a:gs>
                    <a:gs pos="50000">
                      <a:schemeClr val="accent1">
                        <a:lumMod val="60000"/>
                        <a:lumOff val="40000"/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lumMod val="60000"/>
                        <a:lumOff val="40000"/>
                        <a:shade val="100000"/>
                        <a:satMod val="115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extfeld 43"/>
                <p:cNvSpPr txBox="1"/>
                <p:nvPr/>
              </p:nvSpPr>
              <p:spPr>
                <a:xfrm>
                  <a:off x="3599470" y="2504728"/>
                  <a:ext cx="131175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ungal</a:t>
                  </a:r>
                  <a:r>
                    <a:rPr lang="de-D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F MHR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Rechteck: obere Ecken abgeschnitten 27"/>
                <p:cNvSpPr/>
                <p:nvPr/>
              </p:nvSpPr>
              <p:spPr>
                <a:xfrm rot="10800000">
                  <a:off x="3165242" y="2728810"/>
                  <a:ext cx="155737" cy="153541"/>
                </a:xfrm>
                <a:prstGeom prst="snip2SameRect">
                  <a:avLst>
                    <a:gd name="adj1" fmla="val 30625"/>
                    <a:gd name="adj2" fmla="val 0"/>
                  </a:avLst>
                </a:prstGeom>
                <a:gradFill flip="none" rotWithShape="1">
                  <a:gsLst>
                    <a:gs pos="0">
                      <a:schemeClr val="accent2">
                        <a:tint val="66000"/>
                        <a:satMod val="160000"/>
                      </a:schemeClr>
                    </a:gs>
                    <a:gs pos="50000">
                      <a:schemeClr val="accent2">
                        <a:tint val="44500"/>
                        <a:satMod val="160000"/>
                      </a:schemeClr>
                    </a:gs>
                    <a:gs pos="100000">
                      <a:schemeClr val="accent2">
                        <a:tint val="23500"/>
                        <a:satMod val="160000"/>
                      </a:schemeClr>
                    </a:gs>
                  </a:gsLst>
                  <a:lin ang="16200000" scaled="1"/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Textfeld 49"/>
                <p:cNvSpPr txBox="1"/>
                <p:nvPr/>
              </p:nvSpPr>
              <p:spPr>
                <a:xfrm>
                  <a:off x="3008870" y="2541217"/>
                  <a:ext cx="48252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L4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8" name="Gruppieren 77"/>
              <p:cNvGrpSpPr/>
              <p:nvPr/>
            </p:nvGrpSpPr>
            <p:grpSpPr>
              <a:xfrm>
                <a:off x="1017180" y="977492"/>
                <a:ext cx="1368001" cy="2309784"/>
                <a:chOff x="1017180" y="977492"/>
                <a:chExt cx="1368001" cy="2309784"/>
              </a:xfrm>
            </p:grpSpPr>
            <p:cxnSp>
              <p:nvCxnSpPr>
                <p:cNvPr id="18" name="Gerader Verbinder 17"/>
                <p:cNvCxnSpPr/>
                <p:nvPr/>
              </p:nvCxnSpPr>
              <p:spPr>
                <a:xfrm>
                  <a:off x="1323832" y="988136"/>
                  <a:ext cx="1044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Gerader Verbinder 57"/>
                <p:cNvCxnSpPr/>
                <p:nvPr/>
              </p:nvCxnSpPr>
              <p:spPr>
                <a:xfrm>
                  <a:off x="1017181" y="3282529"/>
                  <a:ext cx="136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Gerader Verbinder 58"/>
                <p:cNvCxnSpPr/>
                <p:nvPr/>
              </p:nvCxnSpPr>
              <p:spPr>
                <a:xfrm>
                  <a:off x="1652524" y="1560494"/>
                  <a:ext cx="43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Gerader Verbinder 60"/>
                <p:cNvCxnSpPr/>
                <p:nvPr/>
              </p:nvCxnSpPr>
              <p:spPr>
                <a:xfrm>
                  <a:off x="1304796" y="1977692"/>
                  <a:ext cx="34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Gerader Verbinder 68"/>
                <p:cNvCxnSpPr/>
                <p:nvPr/>
              </p:nvCxnSpPr>
              <p:spPr>
                <a:xfrm>
                  <a:off x="1017180" y="1488302"/>
                  <a:ext cx="30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Gerader Verbinder 69"/>
                <p:cNvCxnSpPr/>
                <p:nvPr/>
              </p:nvCxnSpPr>
              <p:spPr>
                <a:xfrm>
                  <a:off x="1863761" y="2132177"/>
                  <a:ext cx="7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Gerader Verbinder 71"/>
                <p:cNvCxnSpPr/>
                <p:nvPr/>
              </p:nvCxnSpPr>
              <p:spPr>
                <a:xfrm>
                  <a:off x="1854350" y="2702633"/>
                  <a:ext cx="12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Gerader Verbinder 24"/>
                <p:cNvCxnSpPr/>
                <p:nvPr/>
              </p:nvCxnSpPr>
              <p:spPr>
                <a:xfrm>
                  <a:off x="1027457" y="1488302"/>
                  <a:ext cx="0" cy="179897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Gerader Verbinder 72"/>
                <p:cNvCxnSpPr/>
                <p:nvPr/>
              </p:nvCxnSpPr>
              <p:spPr>
                <a:xfrm>
                  <a:off x="1322988" y="977492"/>
                  <a:ext cx="0" cy="10002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Gerader Verbinder 73"/>
                <p:cNvCxnSpPr/>
                <p:nvPr/>
              </p:nvCxnSpPr>
              <p:spPr>
                <a:xfrm>
                  <a:off x="1652524" y="1545381"/>
                  <a:ext cx="0" cy="8748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Gerader Verbinder 74"/>
                <p:cNvCxnSpPr/>
                <p:nvPr/>
              </p:nvCxnSpPr>
              <p:spPr>
                <a:xfrm>
                  <a:off x="1653150" y="2418660"/>
                  <a:ext cx="19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Gerader Verbinder 75"/>
                <p:cNvCxnSpPr/>
                <p:nvPr/>
              </p:nvCxnSpPr>
              <p:spPr>
                <a:xfrm>
                  <a:off x="1863811" y="2122651"/>
                  <a:ext cx="0" cy="57045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9" name="Textfeld 78"/>
              <p:cNvSpPr txBox="1"/>
              <p:nvPr/>
            </p:nvSpPr>
            <p:spPr>
              <a:xfrm>
                <a:off x="2362946" y="3158425"/>
                <a:ext cx="12581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. </a:t>
                </a:r>
                <a:r>
                  <a:rPr lang="de-DE" sz="1000" b="1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inerea</a:t>
                </a:r>
                <a:r>
                  <a:rPr lang="de-DE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GaaR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2" name="Textfeld 81"/>
            <p:cNvSpPr txBox="1"/>
            <p:nvPr/>
          </p:nvSpPr>
          <p:spPr>
            <a:xfrm>
              <a:off x="981107" y="1951906"/>
              <a:ext cx="4242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0.9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feld 82"/>
            <p:cNvSpPr txBox="1"/>
            <p:nvPr/>
          </p:nvSpPr>
          <p:spPr>
            <a:xfrm>
              <a:off x="1250630" y="2386838"/>
              <a:ext cx="4242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0.9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Gerader Verbinder 84"/>
            <p:cNvCxnSpPr/>
            <p:nvPr/>
          </p:nvCxnSpPr>
          <p:spPr>
            <a:xfrm>
              <a:off x="908906" y="3369309"/>
              <a:ext cx="68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feld 85"/>
            <p:cNvSpPr txBox="1"/>
            <p:nvPr/>
          </p:nvSpPr>
          <p:spPr>
            <a:xfrm>
              <a:off x="908906" y="3349774"/>
              <a:ext cx="674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45673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pieren 27"/>
          <p:cNvGrpSpPr/>
          <p:nvPr/>
        </p:nvGrpSpPr>
        <p:grpSpPr>
          <a:xfrm>
            <a:off x="4005064" y="488504"/>
            <a:ext cx="2448272" cy="3247817"/>
            <a:chOff x="3284984" y="560512"/>
            <a:chExt cx="2448272" cy="3247817"/>
          </a:xfrm>
        </p:grpSpPr>
        <p:grpSp>
          <p:nvGrpSpPr>
            <p:cNvPr id="33" name="Gruppieren 32"/>
            <p:cNvGrpSpPr/>
            <p:nvPr/>
          </p:nvGrpSpPr>
          <p:grpSpPr>
            <a:xfrm>
              <a:off x="3284984" y="560512"/>
              <a:ext cx="2448272" cy="3247817"/>
              <a:chOff x="2623312" y="423673"/>
              <a:chExt cx="2448272" cy="3247817"/>
            </a:xfrm>
          </p:grpSpPr>
          <p:graphicFrame>
            <p:nvGraphicFramePr>
              <p:cNvPr id="42" name="Diagramm 41"/>
              <p:cNvGraphicFramePr>
                <a:graphicFrameLocks/>
              </p:cNvGraphicFramePr>
              <p:nvPr>
                <p:extLst/>
              </p:nvPr>
            </p:nvGraphicFramePr>
            <p:xfrm>
              <a:off x="2623312" y="719162"/>
              <a:ext cx="2448272" cy="29523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3" name="Textfeld 42"/>
              <p:cNvSpPr txBox="1"/>
              <p:nvPr/>
            </p:nvSpPr>
            <p:spPr>
              <a:xfrm>
                <a:off x="2628259" y="423673"/>
                <a:ext cx="36004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36" name="Textfeld 35"/>
            <p:cNvSpPr txBox="1"/>
            <p:nvPr/>
          </p:nvSpPr>
          <p:spPr>
            <a:xfrm>
              <a:off x="4134544" y="1631107"/>
              <a:ext cx="5708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37" name="Gruppieren 36"/>
            <p:cNvGrpSpPr/>
            <p:nvPr/>
          </p:nvGrpSpPr>
          <p:grpSpPr>
            <a:xfrm>
              <a:off x="4125019" y="1767795"/>
              <a:ext cx="583200" cy="648000"/>
              <a:chOff x="1244208" y="697338"/>
              <a:chExt cx="583200" cy="648000"/>
            </a:xfrm>
          </p:grpSpPr>
          <p:cxnSp>
            <p:nvCxnSpPr>
              <p:cNvPr id="39" name="Gerader Verbinder 38"/>
              <p:cNvCxnSpPr/>
              <p:nvPr/>
            </p:nvCxnSpPr>
            <p:spPr>
              <a:xfrm>
                <a:off x="1244208" y="697338"/>
                <a:ext cx="583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Gerader Verbinder 39"/>
              <p:cNvCxnSpPr/>
              <p:nvPr/>
            </p:nvCxnSpPr>
            <p:spPr>
              <a:xfrm>
                <a:off x="1824534" y="697338"/>
                <a:ext cx="0" cy="64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Gerader Verbinder 40"/>
              <p:cNvCxnSpPr/>
              <p:nvPr/>
            </p:nvCxnSpPr>
            <p:spPr>
              <a:xfrm>
                <a:off x="1250558" y="698587"/>
                <a:ext cx="0" cy="5907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" name="Gruppieren 10"/>
          <p:cNvGrpSpPr/>
          <p:nvPr/>
        </p:nvGrpSpPr>
        <p:grpSpPr>
          <a:xfrm>
            <a:off x="-836989" y="488504"/>
            <a:ext cx="5634141" cy="2952328"/>
            <a:chOff x="-1053013" y="328519"/>
            <a:chExt cx="5634141" cy="2952328"/>
          </a:xfrm>
        </p:grpSpPr>
        <p:grpSp>
          <p:nvGrpSpPr>
            <p:cNvPr id="5" name="Gruppieren 4"/>
            <p:cNvGrpSpPr/>
            <p:nvPr/>
          </p:nvGrpSpPr>
          <p:grpSpPr>
            <a:xfrm>
              <a:off x="-1053013" y="520190"/>
              <a:ext cx="5634141" cy="2760657"/>
              <a:chOff x="494348" y="618239"/>
              <a:chExt cx="3653899" cy="1790364"/>
            </a:xfrm>
          </p:grpSpPr>
          <p:sp>
            <p:nvSpPr>
              <p:cNvPr id="16" name="Textfeld 15"/>
              <p:cNvSpPr txBox="1"/>
              <p:nvPr/>
            </p:nvSpPr>
            <p:spPr>
              <a:xfrm rot="19200000">
                <a:off x="1729613" y="632207"/>
                <a:ext cx="1177249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cap="small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Rha</a:t>
                </a:r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 rot="19200000">
                <a:off x="2164809" y="618239"/>
                <a:ext cx="1214385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cap="small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Xyl</a:t>
                </a:r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 rot="19200000">
                <a:off x="2624903" y="658020"/>
                <a:ext cx="1079500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ctin</a:t>
                </a:r>
                <a:endParaRPr lang="de-D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 rot="19200000">
                <a:off x="3068747" y="656744"/>
                <a:ext cx="1079500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xylan</a:t>
                </a:r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756700" y="1208584"/>
                <a:ext cx="985292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2" name="Textfeld 21"/>
              <p:cNvSpPr txBox="1"/>
              <p:nvPr/>
            </p:nvSpPr>
            <p:spPr>
              <a:xfrm>
                <a:off x="760623" y="1654957"/>
                <a:ext cx="985292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de-DE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dr-1</a:t>
                </a:r>
              </a:p>
            </p:txBody>
          </p:sp>
          <p:sp>
            <p:nvSpPr>
              <p:cNvPr id="23" name="Textfeld 22"/>
              <p:cNvSpPr txBox="1"/>
              <p:nvPr/>
            </p:nvSpPr>
            <p:spPr>
              <a:xfrm>
                <a:off x="494348" y="2087838"/>
                <a:ext cx="1251567" cy="16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dr-1-comp</a:t>
                </a:r>
              </a:p>
            </p:txBody>
          </p:sp>
          <p:pic>
            <p:nvPicPr>
              <p:cNvPr id="2" name="Grafik 1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099" t="5024" r="1301" b="6762"/>
              <a:stretch/>
            </p:blipFill>
            <p:spPr>
              <a:xfrm>
                <a:off x="1716027" y="1976803"/>
                <a:ext cx="431800" cy="431800"/>
              </a:xfrm>
              <a:prstGeom prst="rect">
                <a:avLst/>
              </a:prstGeom>
            </p:spPr>
          </p:pic>
          <p:pic>
            <p:nvPicPr>
              <p:cNvPr id="3" name="Grafik 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0" t="7452" r="61151" b="4131"/>
              <a:stretch/>
            </p:blipFill>
            <p:spPr>
              <a:xfrm>
                <a:off x="1720843" y="1097647"/>
                <a:ext cx="426984" cy="425475"/>
              </a:xfrm>
              <a:prstGeom prst="rect">
                <a:avLst/>
              </a:prstGeom>
            </p:spPr>
          </p:pic>
          <p:pic>
            <p:nvPicPr>
              <p:cNvPr id="4" name="Grafik 3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0" t="5193" r="33851" b="3808"/>
              <a:stretch/>
            </p:blipFill>
            <p:spPr>
              <a:xfrm>
                <a:off x="1716027" y="1534694"/>
                <a:ext cx="431800" cy="430537"/>
              </a:xfrm>
              <a:prstGeom prst="rect">
                <a:avLst/>
              </a:prstGeom>
            </p:spPr>
          </p:pic>
          <p:pic>
            <p:nvPicPr>
              <p:cNvPr id="8" name="Grafik 7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399" t="381" r="42251" b="5896"/>
              <a:stretch/>
            </p:blipFill>
            <p:spPr>
              <a:xfrm>
                <a:off x="2162096" y="1534694"/>
                <a:ext cx="431169" cy="430537"/>
              </a:xfrm>
              <a:prstGeom prst="rect">
                <a:avLst/>
              </a:prstGeom>
            </p:spPr>
          </p:pic>
          <p:pic>
            <p:nvPicPr>
              <p:cNvPr id="9" name="Grafik 8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430" t="7276" r="39170" b="4709"/>
              <a:stretch/>
            </p:blipFill>
            <p:spPr>
              <a:xfrm>
                <a:off x="2161465" y="1976617"/>
                <a:ext cx="431800" cy="431985"/>
              </a:xfrm>
              <a:prstGeom prst="rect">
                <a:avLst/>
              </a:prstGeom>
            </p:spPr>
          </p:pic>
          <p:pic>
            <p:nvPicPr>
              <p:cNvPr id="10" name="Grafik 9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174" t="3565" r="42476" b="3656"/>
              <a:stretch/>
            </p:blipFill>
            <p:spPr>
              <a:xfrm>
                <a:off x="2158290" y="1097832"/>
                <a:ext cx="434975" cy="425475"/>
              </a:xfrm>
              <a:prstGeom prst="rect">
                <a:avLst/>
              </a:prstGeom>
            </p:spPr>
          </p:pic>
          <p:pic>
            <p:nvPicPr>
              <p:cNvPr id="13" name="Grafik 12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164" t="7328" r="47686" b="7363"/>
              <a:stretch/>
            </p:blipFill>
            <p:spPr>
              <a:xfrm>
                <a:off x="2604604" y="1534694"/>
                <a:ext cx="431800" cy="431800"/>
              </a:xfrm>
              <a:prstGeom prst="rect">
                <a:avLst/>
              </a:prstGeom>
            </p:spPr>
          </p:pic>
          <p:pic>
            <p:nvPicPr>
              <p:cNvPr id="18" name="Grafik 17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199" t="8037" r="2351" b="6048"/>
              <a:stretch/>
            </p:blipFill>
            <p:spPr>
              <a:xfrm>
                <a:off x="2604604" y="1978065"/>
                <a:ext cx="431800" cy="430537"/>
              </a:xfrm>
              <a:prstGeom prst="rect">
                <a:avLst/>
              </a:prstGeom>
            </p:spPr>
          </p:pic>
          <p:pic>
            <p:nvPicPr>
              <p:cNvPr id="24" name="Grafik 23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0" t="4324" r="63250" b="7193"/>
              <a:stretch/>
            </p:blipFill>
            <p:spPr>
              <a:xfrm>
                <a:off x="2604604" y="1092585"/>
                <a:ext cx="431800" cy="431800"/>
              </a:xfrm>
              <a:prstGeom prst="rect">
                <a:avLst/>
              </a:prstGeom>
            </p:spPr>
          </p:pic>
          <p:pic>
            <p:nvPicPr>
              <p:cNvPr id="25" name="Grafik 24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59" t="33186" r="4250" b="35700"/>
              <a:stretch/>
            </p:blipFill>
            <p:spPr>
              <a:xfrm>
                <a:off x="3046572" y="1534694"/>
                <a:ext cx="431800" cy="426462"/>
              </a:xfrm>
              <a:prstGeom prst="rect">
                <a:avLst/>
              </a:prstGeom>
            </p:spPr>
          </p:pic>
          <p:pic>
            <p:nvPicPr>
              <p:cNvPr id="26" name="Grafik 25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3" t="1669" r="7293" b="67217"/>
              <a:stretch/>
            </p:blipFill>
            <p:spPr>
              <a:xfrm>
                <a:off x="3046572" y="1092585"/>
                <a:ext cx="432123" cy="430537"/>
              </a:xfrm>
              <a:prstGeom prst="rect">
                <a:avLst/>
              </a:prstGeom>
            </p:spPr>
          </p:pic>
          <p:pic>
            <p:nvPicPr>
              <p:cNvPr id="27" name="Grafik 26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46" t="67413" r="11844" b="4066"/>
              <a:stretch/>
            </p:blipFill>
            <p:spPr>
              <a:xfrm>
                <a:off x="3046572" y="1978065"/>
                <a:ext cx="431800" cy="430537"/>
              </a:xfrm>
              <a:prstGeom prst="rect">
                <a:avLst/>
              </a:prstGeom>
            </p:spPr>
          </p:pic>
          <p:cxnSp>
            <p:nvCxnSpPr>
              <p:cNvPr id="29" name="Gerader Verbinder 28"/>
              <p:cNvCxnSpPr/>
              <p:nvPr/>
            </p:nvCxnSpPr>
            <p:spPr>
              <a:xfrm>
                <a:off x="1710459" y="1529931"/>
                <a:ext cx="17726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Gerader Verbinder 29"/>
              <p:cNvCxnSpPr/>
              <p:nvPr/>
            </p:nvCxnSpPr>
            <p:spPr>
              <a:xfrm>
                <a:off x="1710503" y="1967877"/>
                <a:ext cx="17726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Gerader Verbinder 30"/>
              <p:cNvCxnSpPr/>
              <p:nvPr/>
            </p:nvCxnSpPr>
            <p:spPr>
              <a:xfrm flipV="1">
                <a:off x="2152090" y="1096565"/>
                <a:ext cx="0" cy="131137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Gerader Verbinder 33"/>
              <p:cNvCxnSpPr/>
              <p:nvPr/>
            </p:nvCxnSpPr>
            <p:spPr>
              <a:xfrm flipV="1">
                <a:off x="2596797" y="1092585"/>
                <a:ext cx="0" cy="131535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Gerader Verbinder 34"/>
              <p:cNvCxnSpPr/>
              <p:nvPr/>
            </p:nvCxnSpPr>
            <p:spPr>
              <a:xfrm flipV="1">
                <a:off x="3036404" y="1092585"/>
                <a:ext cx="0" cy="131579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Rechteck 37"/>
              <p:cNvSpPr/>
              <p:nvPr/>
            </p:nvSpPr>
            <p:spPr>
              <a:xfrm>
                <a:off x="1715862" y="1092585"/>
                <a:ext cx="1762509" cy="131535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sp>
          <p:nvSpPr>
            <p:cNvPr id="50" name="Textfeld 49"/>
            <p:cNvSpPr txBox="1"/>
            <p:nvPr/>
          </p:nvSpPr>
          <p:spPr>
            <a:xfrm>
              <a:off x="42589" y="328519"/>
              <a:ext cx="3711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6" name="Textfeld 5"/>
          <p:cNvSpPr txBox="1"/>
          <p:nvPr/>
        </p:nvSpPr>
        <p:spPr>
          <a:xfrm>
            <a:off x="21943" y="24613"/>
            <a:ext cx="2736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672554" y="3750084"/>
            <a:ext cx="560758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: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rowth phenotypes and protein secretion of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N. crass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WT, Δ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pdr-1-comp strain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bserved growth phenotypes. Strains were grown on either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,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d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yl, 1% pectin or 1% xylan. The cultures were incubated for 3 day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ucrose pregrown cultures were switched to pectin medium and the concentration of secreted protein was determined. Error bars represent standard deviation (n = 3). Significance was determined by an independent two-sampl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est of WT against Δ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dr-1-comp with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5 = *.</a:t>
            </a:r>
          </a:p>
        </p:txBody>
      </p:sp>
    </p:spTree>
    <p:extLst>
      <p:ext uri="{BB962C8B-B14F-4D97-AF65-F5344CB8AC3E}">
        <p14:creationId xmlns:p14="http://schemas.microsoft.com/office/powerpoint/2010/main" val="2238761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Diagramm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0612301"/>
              </p:ext>
            </p:extLst>
          </p:nvPr>
        </p:nvGraphicFramePr>
        <p:xfrm>
          <a:off x="633701" y="2809764"/>
          <a:ext cx="2447054" cy="2134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759" y="495551"/>
            <a:ext cx="2313040" cy="190506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976" y="498662"/>
            <a:ext cx="2304256" cy="1926509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908720" y="2720752"/>
            <a:ext cx="21720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427783" y="2720752"/>
            <a:ext cx="23054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endParaRPr lang="de-DE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76672" y="2423889"/>
            <a:ext cx="3665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76672" y="311174"/>
            <a:ext cx="3665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21943" y="24613"/>
            <a:ext cx="2736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6047454"/>
              </p:ext>
            </p:extLst>
          </p:nvPr>
        </p:nvGraphicFramePr>
        <p:xfrm>
          <a:off x="3065931" y="2823999"/>
          <a:ext cx="2667325" cy="2120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feld 19"/>
          <p:cNvSpPr txBox="1"/>
          <p:nvPr/>
        </p:nvSpPr>
        <p:spPr>
          <a:xfrm>
            <a:off x="476672" y="4943028"/>
            <a:ext cx="5364596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: Venn diagrams of DEseq results and correlation studies of RNA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to RT-qPCR data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ains were pregrown for 16 hours on 2% sucrose and then switched to an induction medium of either 1% pectin (pec) or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Rha for an additional 4 hour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ifferential expression analysis (DEseq) was performed on the RN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ata. Genes of the WT and th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trains that were 3-fold upregulated (left diagram; +) or downregulated (right diagram; -) were compared. Venn diagrams were created with: http://bioinformatics.psb.ugent.be/webtools/Venn/. WT on 1% pectin was used in biological duplicates; all other conditions were used in biological triplicates for the RN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alysi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rrelation analysis of RT-qPCR data to RN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ata. Axes are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caled. The fold change expression of several key pectinase genes was determined by RT-qPCR in the WT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train grown on 1% pectin and plotted against their respective RN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ata. The Pearson’s correlation coefficient (ρ) was determined. Two biological replicates were used for RT-qPCR except fo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ly-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where only one was used. All biological replicates were analyzed as three technical replicates.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2351663" y="3360737"/>
            <a:ext cx="6062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=0.886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939595" y="3364214"/>
            <a:ext cx="6062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=0.999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8595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21943" y="24613"/>
            <a:ext cx="2736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09568" y="6273647"/>
            <a:ext cx="5832648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: Expression levels of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gh28-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NCU09034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determined by RT-qPCR. 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he strains were grown for 2 days on 1% pectin and the expression level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the pdr-1-oex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ain o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gh28-1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the gh28-1-oex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gh28-1-comp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ain was determined. The WT strain was used as reference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he WT and pdr-1-oex strain were incubated for 48 hours on 1% xylan.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Rha was added and the strains were incubated for an additional 30 minutes before harvesting the RNA for RT-qPCR. Strains incubated for the same time but without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Rha were used as controls. The expression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NCU09034 was determined for both strains.</a:t>
            </a:r>
            <a:b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ree biological replicates were used, except fo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WT on pectin and NCU09034 in WT on xylan plus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Rha, where only two were used. All biological replicates were analyzed as three technical replicates. Error bars represent standard deviation. Significance was determined by an independent two-sampl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est with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1 = 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01 = ***.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409568" y="304418"/>
            <a:ext cx="35718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09568" y="2288704"/>
            <a:ext cx="35718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4096452" y="488504"/>
            <a:ext cx="155221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176734" y="489716"/>
            <a:ext cx="212763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900" b="1" i="1" dirty="0">
                <a:latin typeface="Arial" panose="020B0604020202020204" pitchFamily="34" charset="0"/>
                <a:cs typeface="Arial" panose="020B0604020202020204" pitchFamily="34" charset="0"/>
              </a:rPr>
              <a:t>gh28-1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Diagramm 24">
            <a:extLst/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4566880"/>
              </p:ext>
            </p:extLst>
          </p:nvPr>
        </p:nvGraphicFramePr>
        <p:xfrm>
          <a:off x="476672" y="4226954"/>
          <a:ext cx="2520280" cy="2166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3955122" y="2460366"/>
            <a:ext cx="169320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NCU09034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0" name="Gruppieren 89"/>
          <p:cNvGrpSpPr/>
          <p:nvPr/>
        </p:nvGrpSpPr>
        <p:grpSpPr>
          <a:xfrm>
            <a:off x="3282133" y="2656876"/>
            <a:ext cx="2667000" cy="1856580"/>
            <a:chOff x="3282133" y="2472790"/>
            <a:chExt cx="2667000" cy="1990725"/>
          </a:xfrm>
        </p:grpSpPr>
        <p:graphicFrame>
          <p:nvGraphicFramePr>
            <p:cNvPr id="17" name="Diagramm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3627237"/>
                </p:ext>
              </p:extLst>
            </p:nvPr>
          </p:nvGraphicFramePr>
          <p:xfrm>
            <a:off x="3282133" y="2472790"/>
            <a:ext cx="2667000" cy="19907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38" name="Gruppieren 37"/>
            <p:cNvGrpSpPr/>
            <p:nvPr/>
          </p:nvGrpSpPr>
          <p:grpSpPr>
            <a:xfrm>
              <a:off x="4384789" y="2507608"/>
              <a:ext cx="843776" cy="1507512"/>
              <a:chOff x="4384789" y="2507608"/>
              <a:chExt cx="843776" cy="1507512"/>
            </a:xfrm>
          </p:grpSpPr>
          <p:sp>
            <p:nvSpPr>
              <p:cNvPr id="14" name="Textfeld 13"/>
              <p:cNvSpPr txBox="1"/>
              <p:nvPr/>
            </p:nvSpPr>
            <p:spPr>
              <a:xfrm>
                <a:off x="4384789" y="2507608"/>
                <a:ext cx="843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Gerader Verbinder 4"/>
              <p:cNvCxnSpPr/>
              <p:nvPr/>
            </p:nvCxnSpPr>
            <p:spPr>
              <a:xfrm flipV="1">
                <a:off x="5219040" y="2669064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Gerader Verbinder 30"/>
              <p:cNvCxnSpPr/>
              <p:nvPr/>
            </p:nvCxnSpPr>
            <p:spPr>
              <a:xfrm flipV="1">
                <a:off x="4384789" y="2669064"/>
                <a:ext cx="0" cy="134605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Gerader Verbinder 9"/>
              <p:cNvCxnSpPr/>
              <p:nvPr/>
            </p:nvCxnSpPr>
            <p:spPr>
              <a:xfrm flipH="1">
                <a:off x="4384789" y="2669064"/>
                <a:ext cx="835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3" name="Gruppieren 72"/>
          <p:cNvGrpSpPr/>
          <p:nvPr/>
        </p:nvGrpSpPr>
        <p:grpSpPr>
          <a:xfrm>
            <a:off x="3282131" y="4463515"/>
            <a:ext cx="2523133" cy="1926578"/>
            <a:chOff x="3282131" y="4463515"/>
            <a:chExt cx="2523133" cy="1926578"/>
          </a:xfrm>
        </p:grpSpPr>
        <p:graphicFrame>
          <p:nvGraphicFramePr>
            <p:cNvPr id="16" name="Diagramm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64678611"/>
                </p:ext>
              </p:extLst>
            </p:nvPr>
          </p:nvGraphicFramePr>
          <p:xfrm>
            <a:off x="3282131" y="4463515"/>
            <a:ext cx="2523133" cy="1926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36" name="Gruppieren 35"/>
            <p:cNvGrpSpPr/>
            <p:nvPr/>
          </p:nvGrpSpPr>
          <p:grpSpPr>
            <a:xfrm>
              <a:off x="4372050" y="4473644"/>
              <a:ext cx="851157" cy="1511865"/>
              <a:chOff x="4391100" y="4334937"/>
              <a:chExt cx="851157" cy="1696748"/>
            </a:xfrm>
          </p:grpSpPr>
          <p:sp>
            <p:nvSpPr>
              <p:cNvPr id="32" name="Textfeld 31"/>
              <p:cNvSpPr txBox="1"/>
              <p:nvPr/>
            </p:nvSpPr>
            <p:spPr>
              <a:xfrm>
                <a:off x="4391100" y="4334937"/>
                <a:ext cx="846989" cy="27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Gerader Verbinder 32"/>
              <p:cNvCxnSpPr/>
              <p:nvPr/>
            </p:nvCxnSpPr>
            <p:spPr>
              <a:xfrm flipV="1">
                <a:off x="5242257" y="4496395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Gerader Verbinder 33"/>
              <p:cNvCxnSpPr/>
              <p:nvPr/>
            </p:nvCxnSpPr>
            <p:spPr>
              <a:xfrm flipV="1">
                <a:off x="4393679" y="4496395"/>
                <a:ext cx="0" cy="153529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Gerader Verbinder 34"/>
              <p:cNvCxnSpPr/>
              <p:nvPr/>
            </p:nvCxnSpPr>
            <p:spPr>
              <a:xfrm flipH="1">
                <a:off x="4393679" y="4496394"/>
                <a:ext cx="84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41" name="Diagramm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977357"/>
              </p:ext>
            </p:extLst>
          </p:nvPr>
        </p:nvGraphicFramePr>
        <p:xfrm>
          <a:off x="448165" y="4480622"/>
          <a:ext cx="2588567" cy="22379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72" name="Gruppieren 71"/>
          <p:cNvGrpSpPr/>
          <p:nvPr/>
        </p:nvGrpSpPr>
        <p:grpSpPr>
          <a:xfrm>
            <a:off x="667241" y="2460862"/>
            <a:ext cx="2329711" cy="2161527"/>
            <a:chOff x="667241" y="2276776"/>
            <a:chExt cx="2329711" cy="2317706"/>
          </a:xfrm>
        </p:grpSpPr>
        <p:sp>
          <p:nvSpPr>
            <p:cNvPr id="26" name="Textfeld 25"/>
            <p:cNvSpPr txBox="1"/>
            <p:nvPr/>
          </p:nvSpPr>
          <p:spPr>
            <a:xfrm>
              <a:off x="1205793" y="2276776"/>
              <a:ext cx="1674433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dr-1</a:t>
              </a: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0" name="Diagramm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22395541"/>
                </p:ext>
              </p:extLst>
            </p:nvPr>
          </p:nvGraphicFramePr>
          <p:xfrm>
            <a:off x="667241" y="2441832"/>
            <a:ext cx="2329711" cy="21526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68" name="Textfeld 67"/>
            <p:cNvSpPr txBox="1"/>
            <p:nvPr/>
          </p:nvSpPr>
          <p:spPr>
            <a:xfrm>
              <a:off x="1625410" y="2436431"/>
              <a:ext cx="843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Gerader Verbinder 68"/>
            <p:cNvCxnSpPr/>
            <p:nvPr/>
          </p:nvCxnSpPr>
          <p:spPr>
            <a:xfrm flipV="1">
              <a:off x="2459661" y="2603219"/>
              <a:ext cx="0" cy="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r Verbinder 69"/>
            <p:cNvCxnSpPr/>
            <p:nvPr/>
          </p:nvCxnSpPr>
          <p:spPr>
            <a:xfrm flipV="1">
              <a:off x="1606360" y="2594347"/>
              <a:ext cx="0" cy="134605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r Verbinder 70"/>
            <p:cNvCxnSpPr/>
            <p:nvPr/>
          </p:nvCxnSpPr>
          <p:spPr>
            <a:xfrm flipH="1">
              <a:off x="1605411" y="2588105"/>
              <a:ext cx="849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Gruppieren 96"/>
          <p:cNvGrpSpPr/>
          <p:nvPr/>
        </p:nvGrpSpPr>
        <p:grpSpPr>
          <a:xfrm>
            <a:off x="3426553" y="751808"/>
            <a:ext cx="2381249" cy="1666836"/>
            <a:chOff x="3426553" y="655230"/>
            <a:chExt cx="2381249" cy="1525995"/>
          </a:xfrm>
        </p:grpSpPr>
        <p:graphicFrame>
          <p:nvGraphicFramePr>
            <p:cNvPr id="82" name="Diagramm 81">
              <a:extLst>
                <a:ext uri="{FF2B5EF4-FFF2-40B4-BE49-F238E27FC236}">
                  <a16:creationId xmlns="" xmlns:xdr="http://schemas.openxmlformats.org/drawingml/2006/spreadsheetDrawing" xmlns:a16="http://schemas.microsoft.com/office/drawing/2014/main" xmlns:lc="http://schemas.openxmlformats.org/drawingml/2006/lockedCanvas" id="{00000000-0008-0000-0100-000004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02950244"/>
                </p:ext>
              </p:extLst>
            </p:nvPr>
          </p:nvGraphicFramePr>
          <p:xfrm>
            <a:off x="3426553" y="655230"/>
            <a:ext cx="2381249" cy="15259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85" name="Gruppieren 84"/>
            <p:cNvGrpSpPr/>
            <p:nvPr/>
          </p:nvGrpSpPr>
          <p:grpSpPr>
            <a:xfrm>
              <a:off x="4388182" y="662658"/>
              <a:ext cx="853301" cy="1186406"/>
              <a:chOff x="4375264" y="2526658"/>
              <a:chExt cx="853301" cy="1186406"/>
            </a:xfrm>
          </p:grpSpPr>
          <p:sp>
            <p:nvSpPr>
              <p:cNvPr id="86" name="Textfeld 85"/>
              <p:cNvSpPr txBox="1"/>
              <p:nvPr/>
            </p:nvSpPr>
            <p:spPr>
              <a:xfrm>
                <a:off x="4384789" y="2526658"/>
                <a:ext cx="843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Gerader Verbinder 86"/>
              <p:cNvCxnSpPr/>
              <p:nvPr/>
            </p:nvCxnSpPr>
            <p:spPr>
              <a:xfrm flipV="1">
                <a:off x="5219040" y="2669064"/>
                <a:ext cx="0" cy="3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Gerader Verbinder 87"/>
              <p:cNvCxnSpPr/>
              <p:nvPr/>
            </p:nvCxnSpPr>
            <p:spPr>
              <a:xfrm flipV="1">
                <a:off x="4375264" y="2669064"/>
                <a:ext cx="0" cy="104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Gerader Verbinder 88"/>
              <p:cNvCxnSpPr/>
              <p:nvPr/>
            </p:nvCxnSpPr>
            <p:spPr>
              <a:xfrm flipH="1">
                <a:off x="4375264" y="2669064"/>
                <a:ext cx="835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5" name="Gruppieren 104"/>
          <p:cNvGrpSpPr/>
          <p:nvPr/>
        </p:nvGrpSpPr>
        <p:grpSpPr>
          <a:xfrm>
            <a:off x="690158" y="699609"/>
            <a:ext cx="2762249" cy="1812747"/>
            <a:chOff x="690158" y="699609"/>
            <a:chExt cx="2762249" cy="1812747"/>
          </a:xfrm>
        </p:grpSpPr>
        <p:grpSp>
          <p:nvGrpSpPr>
            <p:cNvPr id="98" name="Gruppieren 97"/>
            <p:cNvGrpSpPr/>
            <p:nvPr/>
          </p:nvGrpSpPr>
          <p:grpSpPr>
            <a:xfrm>
              <a:off x="690158" y="699609"/>
              <a:ext cx="2762249" cy="1812747"/>
              <a:chOff x="690158" y="598648"/>
              <a:chExt cx="2762249" cy="1659574"/>
            </a:xfrm>
          </p:grpSpPr>
          <p:graphicFrame>
            <p:nvGraphicFramePr>
              <p:cNvPr id="91" name="Diagramm 90">
                <a:extLst/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60884770"/>
                  </p:ext>
                </p:extLst>
              </p:nvPr>
            </p:nvGraphicFramePr>
            <p:xfrm>
              <a:off x="690158" y="674046"/>
              <a:ext cx="2762249" cy="15841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pSp>
            <p:nvGrpSpPr>
              <p:cNvPr id="92" name="Gruppieren 91"/>
              <p:cNvGrpSpPr/>
              <p:nvPr/>
            </p:nvGrpSpPr>
            <p:grpSpPr>
              <a:xfrm>
                <a:off x="1536681" y="598648"/>
                <a:ext cx="1422000" cy="904906"/>
                <a:chOff x="4375264" y="2500498"/>
                <a:chExt cx="1422000" cy="904906"/>
              </a:xfrm>
            </p:grpSpPr>
            <p:sp>
              <p:nvSpPr>
                <p:cNvPr id="93" name="Textfeld 92"/>
                <p:cNvSpPr txBox="1"/>
                <p:nvPr/>
              </p:nvSpPr>
              <p:spPr>
                <a:xfrm>
                  <a:off x="4384789" y="2500498"/>
                  <a:ext cx="1406646" cy="2254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4" name="Gerader Verbinder 93"/>
                <p:cNvCxnSpPr/>
                <p:nvPr/>
              </p:nvCxnSpPr>
              <p:spPr>
                <a:xfrm flipV="1">
                  <a:off x="5086880" y="2669064"/>
                  <a:ext cx="0" cy="36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Gerader Verbinder 94"/>
                <p:cNvCxnSpPr/>
                <p:nvPr/>
              </p:nvCxnSpPr>
              <p:spPr>
                <a:xfrm flipV="1">
                  <a:off x="4375264" y="2634185"/>
                  <a:ext cx="0" cy="771219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Gerader Verbinder 95"/>
                <p:cNvCxnSpPr/>
                <p:nvPr/>
              </p:nvCxnSpPr>
              <p:spPr>
                <a:xfrm flipH="1">
                  <a:off x="4375264" y="2634182"/>
                  <a:ext cx="142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102" name="Gerader Verbinder 101"/>
            <p:cNvCxnSpPr/>
            <p:nvPr/>
          </p:nvCxnSpPr>
          <p:spPr>
            <a:xfrm flipH="1">
              <a:off x="1535732" y="890261"/>
              <a:ext cx="7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Gerader Verbinder 102"/>
            <p:cNvCxnSpPr/>
            <p:nvPr/>
          </p:nvCxnSpPr>
          <p:spPr>
            <a:xfrm flipV="1">
              <a:off x="2955766" y="845633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83194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Diagramm 15"/>
          <p:cNvGraphicFramePr>
            <a:graphicFrameLocks/>
          </p:cNvGraphicFramePr>
          <p:nvPr>
            <p:extLst/>
          </p:nvPr>
        </p:nvGraphicFramePr>
        <p:xfrm>
          <a:off x="712366" y="732795"/>
          <a:ext cx="2955541" cy="22359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5144129"/>
              </p:ext>
            </p:extLst>
          </p:nvPr>
        </p:nvGraphicFramePr>
        <p:xfrm>
          <a:off x="1572609" y="3033367"/>
          <a:ext cx="3368559" cy="2423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571714" y="480372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571714" y="2828179"/>
            <a:ext cx="2027668" cy="2473010"/>
            <a:chOff x="562189" y="2818654"/>
            <a:chExt cx="2027668" cy="2473010"/>
          </a:xfrm>
        </p:grpSpPr>
        <p:graphicFrame>
          <p:nvGraphicFramePr>
            <p:cNvPr id="4" name="Diagramm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5086673"/>
                </p:ext>
              </p:extLst>
            </p:nvPr>
          </p:nvGraphicFramePr>
          <p:xfrm>
            <a:off x="643722" y="2880971"/>
            <a:ext cx="1946135" cy="24106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" name="Textfeld 6"/>
            <p:cNvSpPr txBox="1"/>
            <p:nvPr/>
          </p:nvSpPr>
          <p:spPr>
            <a:xfrm>
              <a:off x="562189" y="2818654"/>
              <a:ext cx="43204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feld 8"/>
          <p:cNvSpPr txBox="1"/>
          <p:nvPr/>
        </p:nvSpPr>
        <p:spPr>
          <a:xfrm>
            <a:off x="21943" y="24613"/>
            <a:ext cx="2736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53247" y="5457056"/>
            <a:ext cx="4287921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5: Expression profile of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r-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biomass accumulation of the pdr-1-oex strain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profile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r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 After a 16 hour pre-incubation on 2% sucrose, biomass of the WT strain was washed three times with 1x Vogel‘s solution and transferred to a medium of either no carbon source (NoC), 2% sucrose,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 or 1% pectin. The strain was incubated for an additional 4 hours. Error bars represent standard deviation (n = 2 for 1% pectin, n = 3 for NoC, 2% sucrose and 2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)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etermination of accumulated biomass. Strains were grown on 1% xylan with 0.5 mM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l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ha or </a:t>
            </a:r>
            <a:r>
              <a:rPr lang="en-US" sz="1000" cap="small" dirty="0">
                <a:latin typeface="Arial" panose="020B0604020202020204" pitchFamily="34" charset="0"/>
                <a:cs typeface="Arial" panose="020B0604020202020204" pitchFamily="34" charset="0"/>
              </a:rPr>
              <a:t>d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lA. A medium containing 1% xylan was used as control. Biomass was determined by dry weight. Error bars represent standard deviation (n = 3). </a:t>
            </a:r>
          </a:p>
        </p:txBody>
      </p:sp>
    </p:spTree>
    <p:extLst>
      <p:ext uri="{BB962C8B-B14F-4D97-AF65-F5344CB8AC3E}">
        <p14:creationId xmlns:p14="http://schemas.microsoft.com/office/powerpoint/2010/main" val="121631860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06</Words>
  <Application>Microsoft Office PowerPoint</Application>
  <PresentationFormat>A4-Papier (210x297 mm)</PresentationFormat>
  <Paragraphs>77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1_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Leibniz-Rechenzentru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ieme, Nils</dc:creator>
  <cp:lastModifiedBy>Benz, J. Philipp</cp:lastModifiedBy>
  <cp:revision>133</cp:revision>
  <dcterms:created xsi:type="dcterms:W3CDTF">2016-07-07T14:45:49Z</dcterms:created>
  <dcterms:modified xsi:type="dcterms:W3CDTF">2017-03-30T15:43:51Z</dcterms:modified>
</cp:coreProperties>
</file>